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5" r:id="rId2"/>
    <p:sldId id="276" r:id="rId3"/>
    <p:sldId id="277" r:id="rId4"/>
    <p:sldId id="281" r:id="rId5"/>
    <p:sldId id="271" r:id="rId6"/>
    <p:sldId id="282" r:id="rId7"/>
    <p:sldId id="283" r:id="rId8"/>
    <p:sldId id="268" r:id="rId9"/>
    <p:sldId id="269" r:id="rId10"/>
    <p:sldId id="263" r:id="rId11"/>
  </p:sldIdLst>
  <p:sldSz cx="6858000" cy="9144000" type="screen4x3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96">
          <p15:clr>
            <a:srgbClr val="A4A3A4"/>
          </p15:clr>
        </p15:guide>
        <p15:guide id="2" pos="232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brahim Abdelgawad" initials="IA" lastIdx="1" clrIdx="0">
    <p:extLst>
      <p:ext uri="{19B8F6BF-5375-455C-9EA6-DF929625EA0E}">
        <p15:presenceInfo xmlns:p15="http://schemas.microsoft.com/office/powerpoint/2012/main" userId="Ibrahim Abdelgawa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E598"/>
    <a:srgbClr val="E6B8B7"/>
    <a:srgbClr val="C5E0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75" autoAdjust="0"/>
    <p:restoredTop sz="83639" autoAdjust="0"/>
  </p:normalViewPr>
  <p:slideViewPr>
    <p:cSldViewPr>
      <p:cViewPr>
        <p:scale>
          <a:sx n="75" d="100"/>
          <a:sy n="75" d="100"/>
        </p:scale>
        <p:origin x="3042" y="-186"/>
      </p:cViewPr>
      <p:guideLst>
        <p:guide orient="horz" pos="896"/>
        <p:guide pos="2329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3964F5-FE47-4219-BCD6-3C50F37D1893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698500"/>
            <a:ext cx="261937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085"/>
            <a:ext cx="5486400" cy="4191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3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3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9E7E4F-D192-4CE4-AF48-494710D7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71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85854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9524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8923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91340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01934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75820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39830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9313" y="698500"/>
            <a:ext cx="2619375" cy="34925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0804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675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89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92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686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367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404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00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119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963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543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835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3F414-168A-4CF7-B42A-8F56922B0D39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861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g"/><Relationship Id="rId4" Type="http://schemas.openxmlformats.org/officeDocument/2006/relationships/image" Target="../media/image2.jpeg"/><Relationship Id="rId9" Type="http://schemas.openxmlformats.org/officeDocument/2006/relationships/image" Target="../media/image7.jpg"/><Relationship Id="rId14" Type="http://schemas.openxmlformats.org/officeDocument/2006/relationships/image" Target="../media/image12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jpg"/><Relationship Id="rId3" Type="http://schemas.openxmlformats.org/officeDocument/2006/relationships/image" Target="../media/image71.jpg"/><Relationship Id="rId7" Type="http://schemas.openxmlformats.org/officeDocument/2006/relationships/image" Target="../media/image75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4.jpg"/><Relationship Id="rId5" Type="http://schemas.openxmlformats.org/officeDocument/2006/relationships/image" Target="../media/image73.jpg"/><Relationship Id="rId10" Type="http://schemas.openxmlformats.org/officeDocument/2006/relationships/image" Target="../media/image78.jpg"/><Relationship Id="rId4" Type="http://schemas.openxmlformats.org/officeDocument/2006/relationships/image" Target="../media/image72.jpg"/><Relationship Id="rId9" Type="http://schemas.openxmlformats.org/officeDocument/2006/relationships/image" Target="../media/image7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7" Type="http://schemas.openxmlformats.org/officeDocument/2006/relationships/image" Target="../media/image18.jpe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13" Type="http://schemas.openxmlformats.org/officeDocument/2006/relationships/image" Target="../media/image29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12" Type="http://schemas.openxmlformats.org/officeDocument/2006/relationships/image" Target="../media/image28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jpeg"/><Relationship Id="rId11" Type="http://schemas.openxmlformats.org/officeDocument/2006/relationships/image" Target="../media/image27.jpeg"/><Relationship Id="rId5" Type="http://schemas.openxmlformats.org/officeDocument/2006/relationships/image" Target="../media/image21.jpeg"/><Relationship Id="rId15" Type="http://schemas.openxmlformats.org/officeDocument/2006/relationships/image" Target="../media/image31.jpeg"/><Relationship Id="rId10" Type="http://schemas.openxmlformats.org/officeDocument/2006/relationships/image" Target="../media/image26.jpeg"/><Relationship Id="rId4" Type="http://schemas.openxmlformats.org/officeDocument/2006/relationships/image" Target="../media/image20.jpeg"/><Relationship Id="rId9" Type="http://schemas.openxmlformats.org/officeDocument/2006/relationships/image" Target="../media/image25.jpeg"/><Relationship Id="rId14" Type="http://schemas.openxmlformats.org/officeDocument/2006/relationships/image" Target="../media/image3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jpg"/><Relationship Id="rId3" Type="http://schemas.openxmlformats.org/officeDocument/2006/relationships/image" Target="../media/image33.jpg"/><Relationship Id="rId7" Type="http://schemas.openxmlformats.org/officeDocument/2006/relationships/image" Target="../media/image37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jpg"/><Relationship Id="rId5" Type="http://schemas.openxmlformats.org/officeDocument/2006/relationships/image" Target="../media/image35.jpg"/><Relationship Id="rId4" Type="http://schemas.openxmlformats.org/officeDocument/2006/relationships/image" Target="../media/image34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g"/><Relationship Id="rId3" Type="http://schemas.openxmlformats.org/officeDocument/2006/relationships/image" Target="../media/image39.jpg"/><Relationship Id="rId7" Type="http://schemas.openxmlformats.org/officeDocument/2006/relationships/image" Target="../media/image38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jpg"/><Relationship Id="rId5" Type="http://schemas.openxmlformats.org/officeDocument/2006/relationships/image" Target="../media/image41.jpg"/><Relationship Id="rId4" Type="http://schemas.openxmlformats.org/officeDocument/2006/relationships/image" Target="../media/image40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g"/><Relationship Id="rId3" Type="http://schemas.openxmlformats.org/officeDocument/2006/relationships/image" Target="../media/image44.jpg"/><Relationship Id="rId7" Type="http://schemas.openxmlformats.org/officeDocument/2006/relationships/image" Target="../media/image48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jpg"/><Relationship Id="rId5" Type="http://schemas.openxmlformats.org/officeDocument/2006/relationships/image" Target="../media/image46.jpg"/><Relationship Id="rId4" Type="http://schemas.openxmlformats.org/officeDocument/2006/relationships/image" Target="../media/image45.jp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jpg"/><Relationship Id="rId3" Type="http://schemas.openxmlformats.org/officeDocument/2006/relationships/image" Target="../media/image46.jpg"/><Relationship Id="rId7" Type="http://schemas.openxmlformats.org/officeDocument/2006/relationships/image" Target="../media/image52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1.jpg"/><Relationship Id="rId5" Type="http://schemas.openxmlformats.org/officeDocument/2006/relationships/image" Target="../media/image50.jpg"/><Relationship Id="rId4" Type="http://schemas.openxmlformats.org/officeDocument/2006/relationships/image" Target="../media/image49.jp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jpg"/><Relationship Id="rId13" Type="http://schemas.openxmlformats.org/officeDocument/2006/relationships/image" Target="../media/image64.jpeg"/><Relationship Id="rId3" Type="http://schemas.openxmlformats.org/officeDocument/2006/relationships/image" Target="../media/image54.png"/><Relationship Id="rId7" Type="http://schemas.openxmlformats.org/officeDocument/2006/relationships/image" Target="../media/image58.jpg"/><Relationship Id="rId12" Type="http://schemas.openxmlformats.org/officeDocument/2006/relationships/image" Target="../media/image63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7.jpg"/><Relationship Id="rId11" Type="http://schemas.openxmlformats.org/officeDocument/2006/relationships/image" Target="../media/image62.jpeg"/><Relationship Id="rId5" Type="http://schemas.openxmlformats.org/officeDocument/2006/relationships/image" Target="../media/image56.jpg"/><Relationship Id="rId10" Type="http://schemas.openxmlformats.org/officeDocument/2006/relationships/image" Target="../media/image61.jpeg"/><Relationship Id="rId4" Type="http://schemas.openxmlformats.org/officeDocument/2006/relationships/image" Target="../media/image55.jpg"/><Relationship Id="rId9" Type="http://schemas.openxmlformats.org/officeDocument/2006/relationships/image" Target="../media/image60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jpg"/><Relationship Id="rId7" Type="http://schemas.openxmlformats.org/officeDocument/2006/relationships/image" Target="../media/image70.jpg"/><Relationship Id="rId2" Type="http://schemas.openxmlformats.org/officeDocument/2006/relationships/image" Target="../media/image6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jpg"/><Relationship Id="rId5" Type="http://schemas.openxmlformats.org/officeDocument/2006/relationships/image" Target="../media/image68.jpg"/><Relationship Id="rId4" Type="http://schemas.openxmlformats.org/officeDocument/2006/relationships/image" Target="../media/image6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955" y="6219556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-41494" y="7705215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969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1A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2698673"/>
              </p:ext>
            </p:extLst>
          </p:nvPr>
        </p:nvGraphicFramePr>
        <p:xfrm>
          <a:off x="2674870" y="5312197"/>
          <a:ext cx="2118337" cy="578503"/>
        </p:xfrm>
        <a:graphic>
          <a:graphicData uri="http://schemas.openxmlformats.org/drawingml/2006/table">
            <a:tbl>
              <a:tblPr/>
              <a:tblGrid>
                <a:gridCol w="162949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819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2243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52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3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4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5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6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7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8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59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0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solidFill>
                            <a:srgbClr val="000000"/>
                          </a:solidFill>
                          <a:effectLst/>
                        </a:rPr>
                        <a:t>EA 61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2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3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7409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1311258"/>
              </p:ext>
            </p:extLst>
          </p:nvPr>
        </p:nvGraphicFramePr>
        <p:xfrm>
          <a:off x="5157225" y="5335179"/>
          <a:ext cx="1113748" cy="531018"/>
        </p:xfrm>
        <a:graphic>
          <a:graphicData uri="http://schemas.openxmlformats.org/drawingml/2006/table">
            <a:tbl>
              <a:tblPr/>
              <a:tblGrid>
                <a:gridCol w="104525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213688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59107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59107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59107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59107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59107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</a:tblGrid>
              <a:tr h="7524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0418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4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5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6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7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8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solidFill>
                            <a:srgbClr val="000000"/>
                          </a:solidFill>
                          <a:effectLst/>
                        </a:rPr>
                        <a:t>EA 69</a:t>
                      </a:r>
                    </a:p>
                  </a:txBody>
                  <a:tcPr marL="28575" marR="28575" marT="0" marB="0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5159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5413890"/>
              </p:ext>
            </p:extLst>
          </p:nvPr>
        </p:nvGraphicFramePr>
        <p:xfrm>
          <a:off x="749435" y="5326426"/>
          <a:ext cx="1335390" cy="592295"/>
        </p:xfrm>
        <a:graphic>
          <a:graphicData uri="http://schemas.openxmlformats.org/drawingml/2006/table">
            <a:tbl>
              <a:tblPr/>
              <a:tblGrid>
                <a:gridCol w="190770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90770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90770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90770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90770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90770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90770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8268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2437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dirty="0">
                          <a:effectLst/>
                        </a:rPr>
                        <a:t>EA 37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dirty="0">
                          <a:effectLst/>
                        </a:rPr>
                        <a:t>EA 38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dirty="0">
                          <a:effectLst/>
                        </a:rPr>
                        <a:t>EA 39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dirty="0">
                          <a:effectLst/>
                        </a:rPr>
                        <a:t>EA 40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dirty="0">
                          <a:effectLst/>
                        </a:rPr>
                        <a:t>EA 41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dirty="0">
                          <a:effectLst/>
                        </a:rPr>
                        <a:t>EA 42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7647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500" b="1" dirty="0">
                        <a:effectLst/>
                      </a:endParaRPr>
                    </a:p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3076" y="5956283"/>
            <a:ext cx="2446972" cy="146002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3559" y="5942945"/>
            <a:ext cx="1716675" cy="136925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269" y="5956283"/>
            <a:ext cx="1721974" cy="121124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8051" y="7481893"/>
            <a:ext cx="1744116" cy="13531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17" b="32204"/>
          <a:stretch/>
        </p:blipFill>
        <p:spPr>
          <a:xfrm>
            <a:off x="728269" y="7398758"/>
            <a:ext cx="1736725" cy="120783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226" b="6321"/>
          <a:stretch/>
        </p:blipFill>
        <p:spPr>
          <a:xfrm>
            <a:off x="2532997" y="7481893"/>
            <a:ext cx="2457051" cy="155464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7" name="Rectangle 26"/>
          <p:cNvSpPr/>
          <p:nvPr/>
        </p:nvSpPr>
        <p:spPr>
          <a:xfrm>
            <a:off x="3851455" y="7773464"/>
            <a:ext cx="636714" cy="226135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816099" y="6521946"/>
            <a:ext cx="672069" cy="248693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704462" y="5019171"/>
            <a:ext cx="961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1B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0" y="4764025"/>
            <a:ext cx="689094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-46621" y="2000152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39" name="Table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6829454"/>
              </p:ext>
            </p:extLst>
          </p:nvPr>
        </p:nvGraphicFramePr>
        <p:xfrm>
          <a:off x="4608867" y="1078181"/>
          <a:ext cx="2118337" cy="578503"/>
        </p:xfrm>
        <a:graphic>
          <a:graphicData uri="http://schemas.openxmlformats.org/drawingml/2006/table">
            <a:tbl>
              <a:tblPr/>
              <a:tblGrid>
                <a:gridCol w="162949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819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2243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3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4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5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6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7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8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9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0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1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2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3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4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7409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303" b="26583"/>
          <a:stretch/>
        </p:blipFill>
        <p:spPr>
          <a:xfrm>
            <a:off x="4280706" y="2379368"/>
            <a:ext cx="2577294" cy="4696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45" name="Table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0155649"/>
              </p:ext>
            </p:extLst>
          </p:nvPr>
        </p:nvGraphicFramePr>
        <p:xfrm>
          <a:off x="749435" y="1087088"/>
          <a:ext cx="1286256" cy="569595"/>
        </p:xfrm>
        <a:graphic>
          <a:graphicData uri="http://schemas.openxmlformats.org/drawingml/2006/table">
            <a:tbl>
              <a:tblPr/>
              <a:tblGrid>
                <a:gridCol w="91440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28016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71120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71120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71120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71120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71120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71120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6593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3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8319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EA 37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EA 38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EA 39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EA 40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EA 41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EA 42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20465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300" b="1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  <a:endParaRPr lang="en-US" sz="3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3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657" b="6913"/>
          <a:stretch/>
        </p:blipFill>
        <p:spPr>
          <a:xfrm>
            <a:off x="4362018" y="1875314"/>
            <a:ext cx="2486458" cy="36146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7" name="Rectangle 46"/>
          <p:cNvSpPr/>
          <p:nvPr/>
        </p:nvSpPr>
        <p:spPr>
          <a:xfrm>
            <a:off x="4661855" y="1974072"/>
            <a:ext cx="752361" cy="226135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4656167" y="2576376"/>
            <a:ext cx="752361" cy="226135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-60357" y="3435989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749"/>
          <a:stretch/>
        </p:blipFill>
        <p:spPr>
          <a:xfrm>
            <a:off x="2516958" y="1743473"/>
            <a:ext cx="1699028" cy="117433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51" name="Table 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884308"/>
              </p:ext>
            </p:extLst>
          </p:nvPr>
        </p:nvGraphicFramePr>
        <p:xfrm>
          <a:off x="2774017" y="1080395"/>
          <a:ext cx="1346273" cy="578503"/>
        </p:xfrm>
        <a:graphic>
          <a:graphicData uri="http://schemas.openxmlformats.org/drawingml/2006/table">
            <a:tbl>
              <a:tblPr/>
              <a:tblGrid>
                <a:gridCol w="139265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09728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09728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09728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09728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09728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09728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819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2243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6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6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6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6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6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6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dirty="0">
                          <a:effectLst/>
                        </a:rPr>
                        <a:t>EA 31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dirty="0">
                          <a:effectLst/>
                        </a:rPr>
                        <a:t>EA 32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dirty="0">
                          <a:effectLst/>
                        </a:rPr>
                        <a:t>EA 33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dirty="0">
                          <a:effectLst/>
                        </a:rPr>
                        <a:t>EA 34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dirty="0">
                          <a:effectLst/>
                        </a:rPr>
                        <a:t>EA 35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dirty="0">
                          <a:effectLst/>
                        </a:rPr>
                        <a:t>EA 36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7409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2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760" b="13471"/>
          <a:stretch/>
        </p:blipFill>
        <p:spPr>
          <a:xfrm>
            <a:off x="560580" y="1763235"/>
            <a:ext cx="1904414" cy="111830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887" b="11597"/>
          <a:stretch/>
        </p:blipFill>
        <p:spPr>
          <a:xfrm>
            <a:off x="547804" y="3002387"/>
            <a:ext cx="1917190" cy="11991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760" b="5978"/>
          <a:stretch/>
        </p:blipFill>
        <p:spPr>
          <a:xfrm>
            <a:off x="2516958" y="3015070"/>
            <a:ext cx="1699028" cy="118649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906546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00151" y="2150928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CL-w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4415" y="5813320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1237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7 A&amp;B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72874" y="3366290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AK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5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1" t="77163"/>
          <a:stretch/>
        </p:blipFill>
        <p:spPr>
          <a:xfrm>
            <a:off x="844820" y="5426487"/>
            <a:ext cx="2891419" cy="93637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" t="53747" r="-166" b="19090"/>
          <a:stretch/>
        </p:blipFill>
        <p:spPr>
          <a:xfrm>
            <a:off x="844820" y="2977559"/>
            <a:ext cx="2881836" cy="111374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744" b="28559"/>
          <a:stretch/>
        </p:blipFill>
        <p:spPr>
          <a:xfrm>
            <a:off x="846991" y="1735006"/>
            <a:ext cx="2889249" cy="11521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7" t="57493" r="-568" b="14407"/>
          <a:stretch/>
        </p:blipFill>
        <p:spPr>
          <a:xfrm>
            <a:off x="3802917" y="1735007"/>
            <a:ext cx="2928913" cy="11521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4" t="74353" r="1"/>
          <a:stretch/>
        </p:blipFill>
        <p:spPr>
          <a:xfrm>
            <a:off x="3824187" y="5426487"/>
            <a:ext cx="2907643" cy="9363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20027"/>
          <a:stretch/>
        </p:blipFill>
        <p:spPr>
          <a:xfrm>
            <a:off x="3830878" y="2977559"/>
            <a:ext cx="2900952" cy="112236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38" name="Table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8458388"/>
              </p:ext>
            </p:extLst>
          </p:nvPr>
        </p:nvGraphicFramePr>
        <p:xfrm>
          <a:off x="821136" y="968517"/>
          <a:ext cx="2812940" cy="744190"/>
        </p:xfrm>
        <a:graphic>
          <a:graphicData uri="http://schemas.openxmlformats.org/drawingml/2006/table">
            <a:tbl>
              <a:tblPr/>
              <a:tblGrid>
                <a:gridCol w="181042">
                  <a:extLst>
                    <a:ext uri="{9D8B030D-6E8A-4147-A177-3AD203B41FA5}">
                      <a16:colId xmlns:a16="http://schemas.microsoft.com/office/drawing/2014/main" val="4017611445"/>
                    </a:ext>
                  </a:extLst>
                </a:gridCol>
                <a:gridCol w="178894">
                  <a:extLst>
                    <a:ext uri="{9D8B030D-6E8A-4147-A177-3AD203B41FA5}">
                      <a16:colId xmlns:a16="http://schemas.microsoft.com/office/drawing/2014/main" val="2901846887"/>
                    </a:ext>
                  </a:extLst>
                </a:gridCol>
                <a:gridCol w="183190">
                  <a:extLst>
                    <a:ext uri="{9D8B030D-6E8A-4147-A177-3AD203B41FA5}">
                      <a16:colId xmlns:a16="http://schemas.microsoft.com/office/drawing/2014/main" val="1531593738"/>
                    </a:ext>
                  </a:extLst>
                </a:gridCol>
                <a:gridCol w="237619">
                  <a:extLst>
                    <a:ext uri="{9D8B030D-6E8A-4147-A177-3AD203B41FA5}">
                      <a16:colId xmlns:a16="http://schemas.microsoft.com/office/drawing/2014/main" val="2762879117"/>
                    </a:ext>
                  </a:extLst>
                </a:gridCol>
                <a:gridCol w="227161">
                  <a:extLst>
                    <a:ext uri="{9D8B030D-6E8A-4147-A177-3AD203B41FA5}">
                      <a16:colId xmlns:a16="http://schemas.microsoft.com/office/drawing/2014/main" val="1185721839"/>
                    </a:ext>
                  </a:extLst>
                </a:gridCol>
                <a:gridCol w="139470">
                  <a:extLst>
                    <a:ext uri="{9D8B030D-6E8A-4147-A177-3AD203B41FA5}">
                      <a16:colId xmlns:a16="http://schemas.microsoft.com/office/drawing/2014/main" val="800111385"/>
                    </a:ext>
                  </a:extLst>
                </a:gridCol>
                <a:gridCol w="185975">
                  <a:extLst>
                    <a:ext uri="{9D8B030D-6E8A-4147-A177-3AD203B41FA5}">
                      <a16:colId xmlns:a16="http://schemas.microsoft.com/office/drawing/2014/main" val="1334503297"/>
                    </a:ext>
                  </a:extLst>
                </a:gridCol>
                <a:gridCol w="179637">
                  <a:extLst>
                    <a:ext uri="{9D8B030D-6E8A-4147-A177-3AD203B41FA5}">
                      <a16:colId xmlns:a16="http://schemas.microsoft.com/office/drawing/2014/main" val="3123306252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46409084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3162358688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389610847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1773961963"/>
                    </a:ext>
                  </a:extLst>
                </a:gridCol>
                <a:gridCol w="162495">
                  <a:extLst>
                    <a:ext uri="{9D8B030D-6E8A-4147-A177-3AD203B41FA5}">
                      <a16:colId xmlns:a16="http://schemas.microsoft.com/office/drawing/2014/main" val="801284915"/>
                    </a:ext>
                  </a:extLst>
                </a:gridCol>
                <a:gridCol w="209775">
                  <a:extLst>
                    <a:ext uri="{9D8B030D-6E8A-4147-A177-3AD203B41FA5}">
                      <a16:colId xmlns:a16="http://schemas.microsoft.com/office/drawing/2014/main" val="2137659426"/>
                    </a:ext>
                  </a:extLst>
                </a:gridCol>
                <a:gridCol w="115214">
                  <a:extLst>
                    <a:ext uri="{9D8B030D-6E8A-4147-A177-3AD203B41FA5}">
                      <a16:colId xmlns:a16="http://schemas.microsoft.com/office/drawing/2014/main" val="2340412044"/>
                    </a:ext>
                  </a:extLst>
                </a:gridCol>
              </a:tblGrid>
              <a:tr h="14956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9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C9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443380"/>
                  </a:ext>
                </a:extLst>
              </a:tr>
              <a:tr h="2720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67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68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81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82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87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88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79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80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09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12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93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96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605205"/>
                  </a:ext>
                </a:extLst>
              </a:tr>
              <a:tr h="322596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5860197"/>
                  </a:ext>
                </a:extLst>
              </a:tr>
            </a:tbl>
          </a:graphicData>
        </a:graphic>
      </p:graphicFrame>
      <p:graphicFrame>
        <p:nvGraphicFramePr>
          <p:cNvPr id="79" name="Table 7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500368"/>
              </p:ext>
            </p:extLst>
          </p:nvPr>
        </p:nvGraphicFramePr>
        <p:xfrm>
          <a:off x="3918890" y="911981"/>
          <a:ext cx="2812940" cy="744190"/>
        </p:xfrm>
        <a:graphic>
          <a:graphicData uri="http://schemas.openxmlformats.org/drawingml/2006/table">
            <a:tbl>
              <a:tblPr/>
              <a:tblGrid>
                <a:gridCol w="181042">
                  <a:extLst>
                    <a:ext uri="{9D8B030D-6E8A-4147-A177-3AD203B41FA5}">
                      <a16:colId xmlns:a16="http://schemas.microsoft.com/office/drawing/2014/main" val="4017611445"/>
                    </a:ext>
                  </a:extLst>
                </a:gridCol>
                <a:gridCol w="178894">
                  <a:extLst>
                    <a:ext uri="{9D8B030D-6E8A-4147-A177-3AD203B41FA5}">
                      <a16:colId xmlns:a16="http://schemas.microsoft.com/office/drawing/2014/main" val="2901846887"/>
                    </a:ext>
                  </a:extLst>
                </a:gridCol>
                <a:gridCol w="183190">
                  <a:extLst>
                    <a:ext uri="{9D8B030D-6E8A-4147-A177-3AD203B41FA5}">
                      <a16:colId xmlns:a16="http://schemas.microsoft.com/office/drawing/2014/main" val="1531593738"/>
                    </a:ext>
                  </a:extLst>
                </a:gridCol>
                <a:gridCol w="237619">
                  <a:extLst>
                    <a:ext uri="{9D8B030D-6E8A-4147-A177-3AD203B41FA5}">
                      <a16:colId xmlns:a16="http://schemas.microsoft.com/office/drawing/2014/main" val="2762879117"/>
                    </a:ext>
                  </a:extLst>
                </a:gridCol>
                <a:gridCol w="227161">
                  <a:extLst>
                    <a:ext uri="{9D8B030D-6E8A-4147-A177-3AD203B41FA5}">
                      <a16:colId xmlns:a16="http://schemas.microsoft.com/office/drawing/2014/main" val="1185721839"/>
                    </a:ext>
                  </a:extLst>
                </a:gridCol>
                <a:gridCol w="139470">
                  <a:extLst>
                    <a:ext uri="{9D8B030D-6E8A-4147-A177-3AD203B41FA5}">
                      <a16:colId xmlns:a16="http://schemas.microsoft.com/office/drawing/2014/main" val="800111385"/>
                    </a:ext>
                  </a:extLst>
                </a:gridCol>
                <a:gridCol w="185975">
                  <a:extLst>
                    <a:ext uri="{9D8B030D-6E8A-4147-A177-3AD203B41FA5}">
                      <a16:colId xmlns:a16="http://schemas.microsoft.com/office/drawing/2014/main" val="1334503297"/>
                    </a:ext>
                  </a:extLst>
                </a:gridCol>
                <a:gridCol w="179637">
                  <a:extLst>
                    <a:ext uri="{9D8B030D-6E8A-4147-A177-3AD203B41FA5}">
                      <a16:colId xmlns:a16="http://schemas.microsoft.com/office/drawing/2014/main" val="3123306252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46409084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3162358688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389610847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1773961963"/>
                    </a:ext>
                  </a:extLst>
                </a:gridCol>
                <a:gridCol w="162495">
                  <a:extLst>
                    <a:ext uri="{9D8B030D-6E8A-4147-A177-3AD203B41FA5}">
                      <a16:colId xmlns:a16="http://schemas.microsoft.com/office/drawing/2014/main" val="801284915"/>
                    </a:ext>
                  </a:extLst>
                </a:gridCol>
                <a:gridCol w="209775">
                  <a:extLst>
                    <a:ext uri="{9D8B030D-6E8A-4147-A177-3AD203B41FA5}">
                      <a16:colId xmlns:a16="http://schemas.microsoft.com/office/drawing/2014/main" val="2137659426"/>
                    </a:ext>
                  </a:extLst>
                </a:gridCol>
                <a:gridCol w="115214">
                  <a:extLst>
                    <a:ext uri="{9D8B030D-6E8A-4147-A177-3AD203B41FA5}">
                      <a16:colId xmlns:a16="http://schemas.microsoft.com/office/drawing/2014/main" val="2340412044"/>
                    </a:ext>
                  </a:extLst>
                </a:gridCol>
              </a:tblGrid>
              <a:tr h="14956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9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C9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443380"/>
                  </a:ext>
                </a:extLst>
              </a:tr>
              <a:tr h="2720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59</a:t>
                      </a:r>
                    </a:p>
                  </a:txBody>
                  <a:tcPr marL="17635" marR="17635" marT="0" marB="0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60</a:t>
                      </a:r>
                    </a:p>
                  </a:txBody>
                  <a:tcPr marL="17635" marR="17635" marT="0" marB="0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69</a:t>
                      </a:r>
                    </a:p>
                  </a:txBody>
                  <a:tcPr marL="17635" marR="17635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70</a:t>
                      </a:r>
                    </a:p>
                  </a:txBody>
                  <a:tcPr marL="17635" marR="17635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75</a:t>
                      </a:r>
                    </a:p>
                  </a:txBody>
                  <a:tcPr marL="17635" marR="17635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576</a:t>
                      </a:r>
                    </a:p>
                  </a:txBody>
                  <a:tcPr marL="17635" marR="17635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63</a:t>
                      </a:r>
                    </a:p>
                  </a:txBody>
                  <a:tcPr marL="17635" marR="17635" marT="0" marB="0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64</a:t>
                      </a:r>
                    </a:p>
                  </a:txBody>
                  <a:tcPr marL="17635" marR="17635" marT="0" marB="0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15</a:t>
                      </a:r>
                    </a:p>
                  </a:txBody>
                  <a:tcPr marL="17635" marR="17635" marT="0" marB="0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HUV 118</a:t>
                      </a:r>
                    </a:p>
                  </a:txBody>
                  <a:tcPr marL="17635" marR="17635" marT="0" marB="0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389</a:t>
                      </a:r>
                    </a:p>
                  </a:txBody>
                  <a:tcPr marL="17635" marR="17635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EA 392</a:t>
                      </a:r>
                    </a:p>
                  </a:txBody>
                  <a:tcPr marL="17635" marR="17635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605205"/>
                  </a:ext>
                </a:extLst>
              </a:tr>
              <a:tr h="322596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</a:rPr>
                        <a:t>DOX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5860197"/>
                  </a:ext>
                </a:extLst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>
            <a:off x="4057581" y="3043967"/>
            <a:ext cx="417399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1421125" y="3043967"/>
            <a:ext cx="451259" cy="2289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4081885" y="5861414"/>
            <a:ext cx="486927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1969610" y="5902979"/>
            <a:ext cx="460860" cy="2289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4107951" y="2083625"/>
            <a:ext cx="511603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1894090" y="2111332"/>
            <a:ext cx="422455" cy="2289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1480920" y="5889543"/>
            <a:ext cx="391464" cy="2289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/>
          <p:cNvSpPr txBox="1"/>
          <p:nvPr/>
        </p:nvSpPr>
        <p:spPr>
          <a:xfrm>
            <a:off x="196072" y="4513500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0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480"/>
          <a:stretch/>
        </p:blipFill>
        <p:spPr>
          <a:xfrm>
            <a:off x="848886" y="4173942"/>
            <a:ext cx="2887354" cy="112839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8" t="64986" b="5977"/>
          <a:stretch/>
        </p:blipFill>
        <p:spPr>
          <a:xfrm>
            <a:off x="3811382" y="4173942"/>
            <a:ext cx="2911981" cy="112839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5" name="Rectangle 44"/>
          <p:cNvSpPr/>
          <p:nvPr/>
        </p:nvSpPr>
        <p:spPr>
          <a:xfrm>
            <a:off x="4031142" y="4507435"/>
            <a:ext cx="511603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1353663" y="4503390"/>
            <a:ext cx="422455" cy="2289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415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6170" y="2048742"/>
            <a:ext cx="76655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8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8245" y="2750637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08006" y="609601"/>
            <a:ext cx="9553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1C</a:t>
            </a:r>
          </a:p>
        </p:txBody>
      </p:sp>
      <p:graphicFrame>
        <p:nvGraphicFramePr>
          <p:cNvPr id="8" name="Table 7"/>
          <p:cNvGraphicFramePr>
            <a:graphicFrameLocks noGrp="1"/>
          </p:cNvGraphicFramePr>
          <p:nvPr/>
        </p:nvGraphicFramePr>
        <p:xfrm>
          <a:off x="2392066" y="3533572"/>
          <a:ext cx="2227489" cy="740450"/>
        </p:xfrm>
        <a:graphic>
          <a:graphicData uri="http://schemas.openxmlformats.org/drawingml/2006/table">
            <a:tbl>
              <a:tblPr/>
              <a:tblGrid>
                <a:gridCol w="91951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905954915"/>
                    </a:ext>
                  </a:extLst>
                </a:gridCol>
                <a:gridCol w="91951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62053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  <a:gridCol w="98951">
                  <a:extLst>
                    <a:ext uri="{9D8B030D-6E8A-4147-A177-3AD203B41FA5}">
                      <a16:colId xmlns:a16="http://schemas.microsoft.com/office/drawing/2014/main" val="3688343580"/>
                    </a:ext>
                  </a:extLst>
                </a:gridCol>
              </a:tblGrid>
              <a:tr h="1049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847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3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4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5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6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7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8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89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90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91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92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93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94</a:t>
                      </a:r>
                    </a:p>
                  </a:txBody>
                  <a:tcPr marL="17066" marR="17066" marT="11377" marB="11377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35082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1316725" y="1212788"/>
          <a:ext cx="2142821" cy="595215"/>
        </p:xfrm>
        <a:graphic>
          <a:graphicData uri="http://schemas.openxmlformats.org/drawingml/2006/table">
            <a:tbl>
              <a:tblPr/>
              <a:tblGrid>
                <a:gridCol w="221663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45542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45542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45542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45542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45542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45542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74651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74651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74651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74651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74651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74651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899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1885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endParaRPr lang="en-US" sz="90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20643" marR="20643" marT="0" marB="0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dirty="0">
                          <a:effectLst/>
                        </a:rPr>
                        <a:t>EA 31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dirty="0">
                          <a:effectLst/>
                        </a:rPr>
                        <a:t>EA 32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dirty="0">
                          <a:effectLst/>
                        </a:rPr>
                        <a:t>EA 33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dirty="0">
                          <a:effectLst/>
                        </a:rPr>
                        <a:t>EA 34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dirty="0">
                          <a:effectLst/>
                        </a:rPr>
                        <a:t>EA 35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dirty="0">
                          <a:effectLst/>
                        </a:rPr>
                        <a:t>EA 36</a:t>
                      </a:r>
                    </a:p>
                  </a:txBody>
                  <a:tcPr marL="17925" marR="17925" marT="0" marB="0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6967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b="1" dirty="0">
                        <a:effectLst/>
                      </a:endParaRPr>
                    </a:p>
                    <a:p>
                      <a:pPr algn="ctr" rtl="0" fontAlgn="ctr"/>
                      <a:endParaRPr lang="en-US" sz="7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7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7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7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7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7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7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/>
        </p:nvGraphicFramePr>
        <p:xfrm>
          <a:off x="4197100" y="1212788"/>
          <a:ext cx="2118337" cy="578503"/>
        </p:xfrm>
        <a:graphic>
          <a:graphicData uri="http://schemas.openxmlformats.org/drawingml/2006/table">
            <a:tbl>
              <a:tblPr/>
              <a:tblGrid>
                <a:gridCol w="162949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162949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819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2243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3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4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5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6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7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8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59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0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1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2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3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364</a:t>
                      </a:r>
                    </a:p>
                  </a:txBody>
                  <a:tcPr marL="16957" marR="16957" marT="11304" marB="11304" anchor="b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74091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33" b="22837"/>
          <a:stretch/>
        </p:blipFill>
        <p:spPr>
          <a:xfrm>
            <a:off x="1122962" y="2000636"/>
            <a:ext cx="2336583" cy="38016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138245" y="4840835"/>
            <a:ext cx="76655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8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8923" y="631000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416" b="15344"/>
          <a:stretch/>
        </p:blipFill>
        <p:spPr>
          <a:xfrm>
            <a:off x="4081885" y="1923218"/>
            <a:ext cx="2542785" cy="46086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303" b="26584"/>
          <a:stretch/>
        </p:blipFill>
        <p:spPr>
          <a:xfrm>
            <a:off x="3980840" y="2572537"/>
            <a:ext cx="2550855" cy="4879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493" b="8787"/>
          <a:stretch/>
        </p:blipFill>
        <p:spPr>
          <a:xfrm>
            <a:off x="2363417" y="4453130"/>
            <a:ext cx="2409758" cy="11942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416" b="16281"/>
          <a:stretch/>
        </p:blipFill>
        <p:spPr>
          <a:xfrm>
            <a:off x="2360194" y="6108182"/>
            <a:ext cx="2462155" cy="47881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291" b="9660"/>
          <a:stretch/>
        </p:blipFill>
        <p:spPr>
          <a:xfrm>
            <a:off x="1176516" y="2684906"/>
            <a:ext cx="2408334" cy="46525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1" name="Rectangle 20"/>
          <p:cNvSpPr/>
          <p:nvPr/>
        </p:nvSpPr>
        <p:spPr>
          <a:xfrm>
            <a:off x="2468876" y="2144499"/>
            <a:ext cx="614480" cy="236304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2468876" y="2803626"/>
            <a:ext cx="614480" cy="193769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3319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49713" y="4765457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-35055" y="870341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974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1D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-48035" y="7860434"/>
            <a:ext cx="76655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8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5" name="Table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9030985"/>
              </p:ext>
            </p:extLst>
          </p:nvPr>
        </p:nvGraphicFramePr>
        <p:xfrm>
          <a:off x="782126" y="4073569"/>
          <a:ext cx="1891230" cy="548640"/>
        </p:xfrm>
        <a:graphic>
          <a:graphicData uri="http://schemas.openxmlformats.org/drawingml/2006/table">
            <a:tbl>
              <a:tblPr/>
              <a:tblGrid>
                <a:gridCol w="189123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574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334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HUV 13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4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172417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46" name="Table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8874030"/>
              </p:ext>
            </p:extLst>
          </p:nvPr>
        </p:nvGraphicFramePr>
        <p:xfrm>
          <a:off x="5012317" y="4043036"/>
          <a:ext cx="1695864" cy="548640"/>
        </p:xfrm>
        <a:graphic>
          <a:graphicData uri="http://schemas.openxmlformats.org/drawingml/2006/table">
            <a:tbl>
              <a:tblPr/>
              <a:tblGrid>
                <a:gridCol w="91440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574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334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7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7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7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7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7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8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8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8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172417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47" name="Table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0485606"/>
              </p:ext>
            </p:extLst>
          </p:nvPr>
        </p:nvGraphicFramePr>
        <p:xfrm>
          <a:off x="3135674" y="4046266"/>
          <a:ext cx="1645920" cy="579120"/>
        </p:xfrm>
        <a:graphic>
          <a:graphicData uri="http://schemas.openxmlformats.org/drawingml/2006/table">
            <a:tbl>
              <a:tblPr/>
              <a:tblGrid>
                <a:gridCol w="91440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55448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55448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677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5798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7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8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9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0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1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2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3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4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099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effectLst/>
                      </a:endParaRP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48" name="Table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8994314"/>
              </p:ext>
            </p:extLst>
          </p:nvPr>
        </p:nvGraphicFramePr>
        <p:xfrm>
          <a:off x="4762291" y="6807708"/>
          <a:ext cx="1759236" cy="581609"/>
        </p:xfrm>
        <a:graphic>
          <a:graphicData uri="http://schemas.openxmlformats.org/drawingml/2006/table">
            <a:tbl>
              <a:tblPr/>
              <a:tblGrid>
                <a:gridCol w="87962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87962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1535660431"/>
                    </a:ext>
                  </a:extLst>
                </a:gridCol>
                <a:gridCol w="149535">
                  <a:extLst>
                    <a:ext uri="{9D8B030D-6E8A-4147-A177-3AD203B41FA5}">
                      <a16:colId xmlns:a16="http://schemas.microsoft.com/office/drawing/2014/main" val="114832299"/>
                    </a:ext>
                  </a:extLst>
                </a:gridCol>
                <a:gridCol w="87962">
                  <a:extLst>
                    <a:ext uri="{9D8B030D-6E8A-4147-A177-3AD203B41FA5}">
                      <a16:colId xmlns:a16="http://schemas.microsoft.com/office/drawing/2014/main" val="1758927593"/>
                    </a:ext>
                  </a:extLst>
                </a:gridCol>
              </a:tblGrid>
              <a:tr h="9115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1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300" b="1" dirty="0">
                          <a:effectLst/>
                        </a:rPr>
                        <a:t>1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24736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48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49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50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51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52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53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B 256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dirty="0">
                          <a:effectLst/>
                          <a:latin typeface="Calibri" panose="020F0502020204030204" pitchFamily="34" charset="0"/>
                        </a:rPr>
                        <a:t>HUV 257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400" b="1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UV 254</a:t>
                      </a:r>
                    </a:p>
                  </a:txBody>
                  <a:tcPr marL="21836" marR="21836" marT="14557" marB="14557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1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HUV 255</a:t>
                      </a:r>
                    </a:p>
                    <a:p>
                      <a:pPr algn="ctr" rtl="0" fontAlgn="b"/>
                      <a:endParaRPr lang="en-US" sz="400" b="1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1" dirty="0">
                          <a:effectLst/>
                        </a:rPr>
                        <a:t>L</a:t>
                      </a:r>
                    </a:p>
                    <a:p>
                      <a:pPr algn="ctr" rtl="0" fontAlgn="b"/>
                      <a:endParaRPr lang="en-US" sz="4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43089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400" b="1" dirty="0">
                        <a:effectLst/>
                      </a:endParaRPr>
                    </a:p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4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4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49" name="Table 4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663336"/>
              </p:ext>
            </p:extLst>
          </p:nvPr>
        </p:nvGraphicFramePr>
        <p:xfrm>
          <a:off x="717757" y="6862292"/>
          <a:ext cx="1639696" cy="472440"/>
        </p:xfrm>
        <a:graphic>
          <a:graphicData uri="http://schemas.openxmlformats.org/drawingml/2006/table">
            <a:tbl>
              <a:tblPr/>
              <a:tblGrid>
                <a:gridCol w="88412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88412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82859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574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334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7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7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7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7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7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8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8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HUV 8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172417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5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50" name="Table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4444672"/>
              </p:ext>
            </p:extLst>
          </p:nvPr>
        </p:nvGraphicFramePr>
        <p:xfrm>
          <a:off x="2813643" y="6808952"/>
          <a:ext cx="1645920" cy="579120"/>
        </p:xfrm>
        <a:graphic>
          <a:graphicData uri="http://schemas.openxmlformats.org/drawingml/2006/table">
            <a:tbl>
              <a:tblPr/>
              <a:tblGrid>
                <a:gridCol w="91440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55448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55448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677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5798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7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8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9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0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1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2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3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4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099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effectLst/>
                      </a:endParaRP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sp>
        <p:nvSpPr>
          <p:cNvPr id="51" name="TextBox 50"/>
          <p:cNvSpPr txBox="1"/>
          <p:nvPr/>
        </p:nvSpPr>
        <p:spPr>
          <a:xfrm>
            <a:off x="63125" y="5629289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73" t="63297"/>
          <a:stretch/>
        </p:blipFill>
        <p:spPr>
          <a:xfrm>
            <a:off x="2834608" y="4669163"/>
            <a:ext cx="2013579" cy="90605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154" r="13213" b="1374"/>
          <a:stretch/>
        </p:blipFill>
        <p:spPr>
          <a:xfrm>
            <a:off x="2814520" y="5639214"/>
            <a:ext cx="1985197" cy="34341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076" b="38874"/>
          <a:stretch/>
        </p:blipFill>
        <p:spPr>
          <a:xfrm>
            <a:off x="702245" y="7862379"/>
            <a:ext cx="1694095" cy="32727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147" b="36880"/>
          <a:stretch/>
        </p:blipFill>
        <p:spPr>
          <a:xfrm>
            <a:off x="5012317" y="4671527"/>
            <a:ext cx="1695864" cy="79303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430" b="33262"/>
          <a:stretch/>
        </p:blipFill>
        <p:spPr>
          <a:xfrm>
            <a:off x="4947945" y="5689813"/>
            <a:ext cx="1824608" cy="29281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430" b="33794"/>
          <a:stretch/>
        </p:blipFill>
        <p:spPr>
          <a:xfrm>
            <a:off x="704014" y="8717003"/>
            <a:ext cx="1694095" cy="23237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097" r="3779"/>
          <a:stretch/>
        </p:blipFill>
        <p:spPr>
          <a:xfrm>
            <a:off x="4734770" y="7526543"/>
            <a:ext cx="2070352" cy="99894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1" t="87988" r="18535" b="3652"/>
          <a:stretch/>
        </p:blipFill>
        <p:spPr>
          <a:xfrm>
            <a:off x="4816201" y="8680302"/>
            <a:ext cx="1651415" cy="30577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43" b="29393"/>
          <a:stretch/>
        </p:blipFill>
        <p:spPr>
          <a:xfrm>
            <a:off x="776429" y="4696466"/>
            <a:ext cx="1942066" cy="76810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040" b="9501"/>
          <a:stretch/>
        </p:blipFill>
        <p:spPr>
          <a:xfrm>
            <a:off x="782126" y="5710302"/>
            <a:ext cx="1936369" cy="25183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6" name="Rectangle 65"/>
          <p:cNvSpPr/>
          <p:nvPr/>
        </p:nvSpPr>
        <p:spPr>
          <a:xfrm>
            <a:off x="3121760" y="4835369"/>
            <a:ext cx="729695" cy="2347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3044950" y="5686932"/>
            <a:ext cx="806505" cy="2347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290" r="12651" b="13470"/>
          <a:stretch/>
        </p:blipFill>
        <p:spPr>
          <a:xfrm>
            <a:off x="2491555" y="7832157"/>
            <a:ext cx="2089595" cy="36668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1" name="Rectangle 70"/>
          <p:cNvSpPr/>
          <p:nvPr/>
        </p:nvSpPr>
        <p:spPr>
          <a:xfrm>
            <a:off x="3697836" y="7946019"/>
            <a:ext cx="806505" cy="2347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131468" y="1898177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4988" y="2434333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154" r="13213" b="1374"/>
          <a:stretch/>
        </p:blipFill>
        <p:spPr>
          <a:xfrm>
            <a:off x="2826383" y="2444258"/>
            <a:ext cx="1985197" cy="34341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509" r="11478" b="198"/>
          <a:stretch/>
        </p:blipFill>
        <p:spPr>
          <a:xfrm>
            <a:off x="2834490" y="1902555"/>
            <a:ext cx="1977090" cy="34159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380" b="38760"/>
          <a:stretch/>
        </p:blipFill>
        <p:spPr>
          <a:xfrm>
            <a:off x="786691" y="1886991"/>
            <a:ext cx="1943667" cy="45058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040" b="9501"/>
          <a:stretch/>
        </p:blipFill>
        <p:spPr>
          <a:xfrm>
            <a:off x="793989" y="2515346"/>
            <a:ext cx="1936369" cy="25183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1" name="Rectangle 60"/>
          <p:cNvSpPr/>
          <p:nvPr/>
        </p:nvSpPr>
        <p:spPr>
          <a:xfrm>
            <a:off x="1002463" y="2053139"/>
            <a:ext cx="806505" cy="2347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940776" y="2503723"/>
            <a:ext cx="806505" cy="23479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63" name="Table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7710075"/>
              </p:ext>
            </p:extLst>
          </p:nvPr>
        </p:nvGraphicFramePr>
        <p:xfrm>
          <a:off x="813065" y="1261268"/>
          <a:ext cx="1891230" cy="548640"/>
        </p:xfrm>
        <a:graphic>
          <a:graphicData uri="http://schemas.openxmlformats.org/drawingml/2006/table">
            <a:tbl>
              <a:tblPr/>
              <a:tblGrid>
                <a:gridCol w="189123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89123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574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334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HUV 13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3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HUV 14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172417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graphicFrame>
        <p:nvGraphicFramePr>
          <p:cNvPr id="64" name="Table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6451816"/>
              </p:ext>
            </p:extLst>
          </p:nvPr>
        </p:nvGraphicFramePr>
        <p:xfrm>
          <a:off x="3166613" y="1233965"/>
          <a:ext cx="1645920" cy="579120"/>
        </p:xfrm>
        <a:graphic>
          <a:graphicData uri="http://schemas.openxmlformats.org/drawingml/2006/table">
            <a:tbl>
              <a:tblPr/>
              <a:tblGrid>
                <a:gridCol w="91440">
                  <a:extLst>
                    <a:ext uri="{9D8B030D-6E8A-4147-A177-3AD203B41FA5}">
                      <a16:colId xmlns:a16="http://schemas.microsoft.com/office/drawing/2014/main" val="1852657266"/>
                    </a:ext>
                  </a:extLst>
                </a:gridCol>
                <a:gridCol w="155448">
                  <a:extLst>
                    <a:ext uri="{9D8B030D-6E8A-4147-A177-3AD203B41FA5}">
                      <a16:colId xmlns:a16="http://schemas.microsoft.com/office/drawing/2014/main" val="606696773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2450601301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2782169007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168295282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496626678"/>
                    </a:ext>
                  </a:extLst>
                </a:gridCol>
                <a:gridCol w="155448">
                  <a:extLst>
                    <a:ext uri="{9D8B030D-6E8A-4147-A177-3AD203B41FA5}">
                      <a16:colId xmlns:a16="http://schemas.microsoft.com/office/drawing/2014/main" val="2964388543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554547852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3811433517"/>
                    </a:ext>
                  </a:extLst>
                </a:gridCol>
                <a:gridCol w="192024">
                  <a:extLst>
                    <a:ext uri="{9D8B030D-6E8A-4147-A177-3AD203B41FA5}">
                      <a16:colId xmlns:a16="http://schemas.microsoft.com/office/drawing/2014/main" val="3070298534"/>
                    </a:ext>
                  </a:extLst>
                </a:gridCol>
              </a:tblGrid>
              <a:tr h="6770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3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CA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6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8D0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E8D1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6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705488"/>
                  </a:ext>
                </a:extLst>
              </a:tr>
              <a:tr h="15798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7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D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8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D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9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0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E8DE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C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1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2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2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08E7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3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4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94</a:t>
                      </a:r>
                    </a:p>
                  </a:txBody>
                  <a:tcPr marL="0" marR="0" marT="15240" marB="15240" anchor="ctr">
                    <a:lnL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68E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19706"/>
                  </a:ext>
                </a:extLst>
              </a:tr>
              <a:tr h="20997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effectLst/>
                      </a:endParaRP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E6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A8E8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28E9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3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effectLst/>
                        </a:rPr>
                        <a:t>CTL</a:t>
                      </a:r>
                    </a:p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48F57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1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2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0.5 µM</a:t>
                      </a:r>
                    </a:p>
                    <a:p>
                      <a:pPr algn="ctr" rtl="0" fontAlgn="ctr"/>
                      <a:r>
                        <a:rPr lang="en-US" sz="600" b="1" dirty="0">
                          <a:solidFill>
                            <a:srgbClr val="FF0000"/>
                          </a:solidFill>
                          <a:effectLst/>
                        </a:rPr>
                        <a:t>DOX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669103"/>
                  </a:ext>
                </a:extLst>
              </a:tr>
            </a:tbl>
          </a:graphicData>
        </a:graphic>
      </p:graphicFrame>
      <p:cxnSp>
        <p:nvCxnSpPr>
          <p:cNvPr id="65" name="Straight Connector 64"/>
          <p:cNvCxnSpPr/>
          <p:nvPr/>
        </p:nvCxnSpPr>
        <p:spPr>
          <a:xfrm>
            <a:off x="0" y="3151015"/>
            <a:ext cx="689094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033655" y="3249557"/>
            <a:ext cx="9489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1E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033655" y="6299688"/>
            <a:ext cx="942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1F</a:t>
            </a:r>
          </a:p>
        </p:txBody>
      </p:sp>
      <p:cxnSp>
        <p:nvCxnSpPr>
          <p:cNvPr id="77" name="Straight Connector 76"/>
          <p:cNvCxnSpPr/>
          <p:nvPr/>
        </p:nvCxnSpPr>
        <p:spPr>
          <a:xfrm>
            <a:off x="-32948" y="6294824"/>
            <a:ext cx="689094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339" r="9221" b="2969"/>
          <a:stretch/>
        </p:blipFill>
        <p:spPr>
          <a:xfrm>
            <a:off x="2580919" y="8670028"/>
            <a:ext cx="2111367" cy="3154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2" name="Rectangle 71"/>
          <p:cNvSpPr/>
          <p:nvPr/>
        </p:nvSpPr>
        <p:spPr>
          <a:xfrm>
            <a:off x="3697836" y="8755785"/>
            <a:ext cx="761728" cy="22964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7053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10206" y="2141308"/>
            <a:ext cx="8861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17,19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969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6A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26922" y="3833678"/>
            <a:ext cx="8902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otal caspase-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5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38" name="Table 37"/>
          <p:cNvGraphicFramePr>
            <a:graphicFrameLocks noGrp="1"/>
          </p:cNvGraphicFramePr>
          <p:nvPr/>
        </p:nvGraphicFramePr>
        <p:xfrm>
          <a:off x="858600" y="959024"/>
          <a:ext cx="2800830" cy="752829"/>
        </p:xfrm>
        <a:graphic>
          <a:graphicData uri="http://schemas.openxmlformats.org/drawingml/2006/table">
            <a:tbl>
              <a:tblPr/>
              <a:tblGrid>
                <a:gridCol w="144443">
                  <a:extLst>
                    <a:ext uri="{9D8B030D-6E8A-4147-A177-3AD203B41FA5}">
                      <a16:colId xmlns:a16="http://schemas.microsoft.com/office/drawing/2014/main" val="4017611445"/>
                    </a:ext>
                  </a:extLst>
                </a:gridCol>
                <a:gridCol w="202288">
                  <a:extLst>
                    <a:ext uri="{9D8B030D-6E8A-4147-A177-3AD203B41FA5}">
                      <a16:colId xmlns:a16="http://schemas.microsoft.com/office/drawing/2014/main" val="2901846887"/>
                    </a:ext>
                  </a:extLst>
                </a:gridCol>
                <a:gridCol w="176469">
                  <a:extLst>
                    <a:ext uri="{9D8B030D-6E8A-4147-A177-3AD203B41FA5}">
                      <a16:colId xmlns:a16="http://schemas.microsoft.com/office/drawing/2014/main" val="1531593738"/>
                    </a:ext>
                  </a:extLst>
                </a:gridCol>
                <a:gridCol w="228901">
                  <a:extLst>
                    <a:ext uri="{9D8B030D-6E8A-4147-A177-3AD203B41FA5}">
                      <a16:colId xmlns:a16="http://schemas.microsoft.com/office/drawing/2014/main" val="2762879117"/>
                    </a:ext>
                  </a:extLst>
                </a:gridCol>
                <a:gridCol w="169258">
                  <a:extLst>
                    <a:ext uri="{9D8B030D-6E8A-4147-A177-3AD203B41FA5}">
                      <a16:colId xmlns:a16="http://schemas.microsoft.com/office/drawing/2014/main" val="1185721839"/>
                    </a:ext>
                  </a:extLst>
                </a:gridCol>
                <a:gridCol w="184980">
                  <a:extLst>
                    <a:ext uri="{9D8B030D-6E8A-4147-A177-3AD203B41FA5}">
                      <a16:colId xmlns:a16="http://schemas.microsoft.com/office/drawing/2014/main" val="800111385"/>
                    </a:ext>
                  </a:extLst>
                </a:gridCol>
                <a:gridCol w="178094">
                  <a:extLst>
                    <a:ext uri="{9D8B030D-6E8A-4147-A177-3AD203B41FA5}">
                      <a16:colId xmlns:a16="http://schemas.microsoft.com/office/drawing/2014/main" val="1334503297"/>
                    </a:ext>
                  </a:extLst>
                </a:gridCol>
                <a:gridCol w="173046">
                  <a:extLst>
                    <a:ext uri="{9D8B030D-6E8A-4147-A177-3AD203B41FA5}">
                      <a16:colId xmlns:a16="http://schemas.microsoft.com/office/drawing/2014/main" val="3123306252"/>
                    </a:ext>
                  </a:extLst>
                </a:gridCol>
                <a:gridCol w="195665">
                  <a:extLst>
                    <a:ext uri="{9D8B030D-6E8A-4147-A177-3AD203B41FA5}">
                      <a16:colId xmlns:a16="http://schemas.microsoft.com/office/drawing/2014/main" val="464090841"/>
                    </a:ext>
                  </a:extLst>
                </a:gridCol>
                <a:gridCol w="156118">
                  <a:extLst>
                    <a:ext uri="{9D8B030D-6E8A-4147-A177-3AD203B41FA5}">
                      <a16:colId xmlns:a16="http://schemas.microsoft.com/office/drawing/2014/main" val="3162358688"/>
                    </a:ext>
                  </a:extLst>
                </a:gridCol>
                <a:gridCol w="235212">
                  <a:extLst>
                    <a:ext uri="{9D8B030D-6E8A-4147-A177-3AD203B41FA5}">
                      <a16:colId xmlns:a16="http://schemas.microsoft.com/office/drawing/2014/main" val="3896108471"/>
                    </a:ext>
                  </a:extLst>
                </a:gridCol>
                <a:gridCol w="195665">
                  <a:extLst>
                    <a:ext uri="{9D8B030D-6E8A-4147-A177-3AD203B41FA5}">
                      <a16:colId xmlns:a16="http://schemas.microsoft.com/office/drawing/2014/main" val="1773961963"/>
                    </a:ext>
                  </a:extLst>
                </a:gridCol>
                <a:gridCol w="156533">
                  <a:extLst>
                    <a:ext uri="{9D8B030D-6E8A-4147-A177-3AD203B41FA5}">
                      <a16:colId xmlns:a16="http://schemas.microsoft.com/office/drawing/2014/main" val="801284915"/>
                    </a:ext>
                  </a:extLst>
                </a:gridCol>
                <a:gridCol w="202079">
                  <a:extLst>
                    <a:ext uri="{9D8B030D-6E8A-4147-A177-3AD203B41FA5}">
                      <a16:colId xmlns:a16="http://schemas.microsoft.com/office/drawing/2014/main" val="2137659426"/>
                    </a:ext>
                  </a:extLst>
                </a:gridCol>
                <a:gridCol w="202079">
                  <a:extLst>
                    <a:ext uri="{9D8B030D-6E8A-4147-A177-3AD203B41FA5}">
                      <a16:colId xmlns:a16="http://schemas.microsoft.com/office/drawing/2014/main" val="3877760550"/>
                    </a:ext>
                  </a:extLst>
                </a:gridCol>
              </a:tblGrid>
              <a:tr h="15130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6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8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443380"/>
                  </a:ext>
                </a:extLst>
              </a:tr>
              <a:tr h="27518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69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0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2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3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5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76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8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77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7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88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0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9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605205"/>
                  </a:ext>
                </a:extLst>
              </a:tr>
              <a:tr h="326341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5860197"/>
                  </a:ext>
                </a:extLst>
              </a:tr>
            </a:tbl>
          </a:graphicData>
        </a:graphic>
      </p:graphicFrame>
      <p:graphicFrame>
        <p:nvGraphicFramePr>
          <p:cNvPr id="35" name="Table 34"/>
          <p:cNvGraphicFramePr>
            <a:graphicFrameLocks noGrp="1"/>
          </p:cNvGraphicFramePr>
          <p:nvPr/>
        </p:nvGraphicFramePr>
        <p:xfrm>
          <a:off x="3955178" y="968517"/>
          <a:ext cx="2697726" cy="744190"/>
        </p:xfrm>
        <a:graphic>
          <a:graphicData uri="http://schemas.openxmlformats.org/drawingml/2006/table">
            <a:tbl>
              <a:tblPr/>
              <a:tblGrid>
                <a:gridCol w="149944">
                  <a:extLst>
                    <a:ext uri="{9D8B030D-6E8A-4147-A177-3AD203B41FA5}">
                      <a16:colId xmlns:a16="http://schemas.microsoft.com/office/drawing/2014/main" val="4017611445"/>
                    </a:ext>
                  </a:extLst>
                </a:gridCol>
                <a:gridCol w="209992">
                  <a:extLst>
                    <a:ext uri="{9D8B030D-6E8A-4147-A177-3AD203B41FA5}">
                      <a16:colId xmlns:a16="http://schemas.microsoft.com/office/drawing/2014/main" val="2901846887"/>
                    </a:ext>
                  </a:extLst>
                </a:gridCol>
                <a:gridCol w="183190">
                  <a:extLst>
                    <a:ext uri="{9D8B030D-6E8A-4147-A177-3AD203B41FA5}">
                      <a16:colId xmlns:a16="http://schemas.microsoft.com/office/drawing/2014/main" val="1531593738"/>
                    </a:ext>
                  </a:extLst>
                </a:gridCol>
                <a:gridCol w="237619">
                  <a:extLst>
                    <a:ext uri="{9D8B030D-6E8A-4147-A177-3AD203B41FA5}">
                      <a16:colId xmlns:a16="http://schemas.microsoft.com/office/drawing/2014/main" val="2762879117"/>
                    </a:ext>
                  </a:extLst>
                </a:gridCol>
                <a:gridCol w="175704">
                  <a:extLst>
                    <a:ext uri="{9D8B030D-6E8A-4147-A177-3AD203B41FA5}">
                      <a16:colId xmlns:a16="http://schemas.microsoft.com/office/drawing/2014/main" val="1185721839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800111385"/>
                    </a:ext>
                  </a:extLst>
                </a:gridCol>
                <a:gridCol w="184877">
                  <a:extLst>
                    <a:ext uri="{9D8B030D-6E8A-4147-A177-3AD203B41FA5}">
                      <a16:colId xmlns:a16="http://schemas.microsoft.com/office/drawing/2014/main" val="1334503297"/>
                    </a:ext>
                  </a:extLst>
                </a:gridCol>
                <a:gridCol w="179637">
                  <a:extLst>
                    <a:ext uri="{9D8B030D-6E8A-4147-A177-3AD203B41FA5}">
                      <a16:colId xmlns:a16="http://schemas.microsoft.com/office/drawing/2014/main" val="3123306252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464090841"/>
                    </a:ext>
                  </a:extLst>
                </a:gridCol>
                <a:gridCol w="162064">
                  <a:extLst>
                    <a:ext uri="{9D8B030D-6E8A-4147-A177-3AD203B41FA5}">
                      <a16:colId xmlns:a16="http://schemas.microsoft.com/office/drawing/2014/main" val="3162358688"/>
                    </a:ext>
                  </a:extLst>
                </a:gridCol>
                <a:gridCol w="244170">
                  <a:extLst>
                    <a:ext uri="{9D8B030D-6E8A-4147-A177-3AD203B41FA5}">
                      <a16:colId xmlns:a16="http://schemas.microsoft.com/office/drawing/2014/main" val="389610847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1773961963"/>
                    </a:ext>
                  </a:extLst>
                </a:gridCol>
                <a:gridCol w="162495">
                  <a:extLst>
                    <a:ext uri="{9D8B030D-6E8A-4147-A177-3AD203B41FA5}">
                      <a16:colId xmlns:a16="http://schemas.microsoft.com/office/drawing/2014/main" val="801284915"/>
                    </a:ext>
                  </a:extLst>
                </a:gridCol>
                <a:gridCol w="209775">
                  <a:extLst>
                    <a:ext uri="{9D8B030D-6E8A-4147-A177-3AD203B41FA5}">
                      <a16:colId xmlns:a16="http://schemas.microsoft.com/office/drawing/2014/main" val="2137659426"/>
                    </a:ext>
                  </a:extLst>
                </a:gridCol>
              </a:tblGrid>
              <a:tr h="14956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6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8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443380"/>
                  </a:ext>
                </a:extLst>
              </a:tr>
              <a:tr h="2720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1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2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5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3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4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6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7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8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0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1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9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2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605205"/>
                  </a:ext>
                </a:extLst>
              </a:tr>
              <a:tr h="322596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Fisetin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Fisetin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Fisetin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5860197"/>
                  </a:ext>
                </a:extLst>
              </a:tr>
            </a:tbl>
          </a:graphicData>
        </a:graphic>
      </p:graphicFrame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874" b="12534"/>
          <a:stretch/>
        </p:blipFill>
        <p:spPr>
          <a:xfrm>
            <a:off x="3861452" y="1822842"/>
            <a:ext cx="2870378" cy="155747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346" b="12534"/>
          <a:stretch/>
        </p:blipFill>
        <p:spPr>
          <a:xfrm>
            <a:off x="3813050" y="3483853"/>
            <a:ext cx="2883188" cy="143999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5" name="TextBox 44"/>
          <p:cNvSpPr txBox="1"/>
          <p:nvPr/>
        </p:nvSpPr>
        <p:spPr>
          <a:xfrm>
            <a:off x="25095" y="5378505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113" b="13471"/>
          <a:stretch/>
        </p:blipFill>
        <p:spPr>
          <a:xfrm>
            <a:off x="789851" y="1822842"/>
            <a:ext cx="2869579" cy="9601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480" b="18154"/>
          <a:stretch/>
        </p:blipFill>
        <p:spPr>
          <a:xfrm>
            <a:off x="789851" y="5378505"/>
            <a:ext cx="2869579" cy="3840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796" b="22837"/>
          <a:stretch/>
        </p:blipFill>
        <p:spPr>
          <a:xfrm>
            <a:off x="789851" y="3794582"/>
            <a:ext cx="2869579" cy="3840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0" name="Rectangle 49"/>
          <p:cNvSpPr/>
          <p:nvPr/>
        </p:nvSpPr>
        <p:spPr>
          <a:xfrm>
            <a:off x="1008006" y="2273010"/>
            <a:ext cx="868607" cy="338180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1062187" y="3956339"/>
            <a:ext cx="868607" cy="26989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990600" y="5551132"/>
            <a:ext cx="868607" cy="26989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668" b="20028"/>
          <a:stretch/>
        </p:blipFill>
        <p:spPr>
          <a:xfrm>
            <a:off x="3763648" y="5364604"/>
            <a:ext cx="2981992" cy="3979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801287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974" y="1948251"/>
            <a:ext cx="6850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89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177" b="20026"/>
          <a:stretch/>
        </p:blipFill>
        <p:spPr>
          <a:xfrm>
            <a:off x="833272" y="1959934"/>
            <a:ext cx="2960477" cy="7296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860" b="20027"/>
          <a:stretch/>
        </p:blipFill>
        <p:spPr>
          <a:xfrm>
            <a:off x="811778" y="2908376"/>
            <a:ext cx="2960477" cy="53767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-27450" y="3050314"/>
            <a:ext cx="8902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otal PARP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116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869" b="19955"/>
          <a:stretch/>
        </p:blipFill>
        <p:spPr>
          <a:xfrm>
            <a:off x="3868383" y="2031649"/>
            <a:ext cx="2784521" cy="60809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923" b="23774"/>
          <a:stretch/>
        </p:blipFill>
        <p:spPr>
          <a:xfrm>
            <a:off x="3868383" y="2920585"/>
            <a:ext cx="2901852" cy="52546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08006" y="609601"/>
            <a:ext cx="961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6B</a:t>
            </a: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9812428"/>
              </p:ext>
            </p:extLst>
          </p:nvPr>
        </p:nvGraphicFramePr>
        <p:xfrm>
          <a:off x="821136" y="968517"/>
          <a:ext cx="2697726" cy="744190"/>
        </p:xfrm>
        <a:graphic>
          <a:graphicData uri="http://schemas.openxmlformats.org/drawingml/2006/table">
            <a:tbl>
              <a:tblPr/>
              <a:tblGrid>
                <a:gridCol w="149944">
                  <a:extLst>
                    <a:ext uri="{9D8B030D-6E8A-4147-A177-3AD203B41FA5}">
                      <a16:colId xmlns:a16="http://schemas.microsoft.com/office/drawing/2014/main" val="4017611445"/>
                    </a:ext>
                  </a:extLst>
                </a:gridCol>
                <a:gridCol w="209992">
                  <a:extLst>
                    <a:ext uri="{9D8B030D-6E8A-4147-A177-3AD203B41FA5}">
                      <a16:colId xmlns:a16="http://schemas.microsoft.com/office/drawing/2014/main" val="2901846887"/>
                    </a:ext>
                  </a:extLst>
                </a:gridCol>
                <a:gridCol w="183190">
                  <a:extLst>
                    <a:ext uri="{9D8B030D-6E8A-4147-A177-3AD203B41FA5}">
                      <a16:colId xmlns:a16="http://schemas.microsoft.com/office/drawing/2014/main" val="1531593738"/>
                    </a:ext>
                  </a:extLst>
                </a:gridCol>
                <a:gridCol w="237619">
                  <a:extLst>
                    <a:ext uri="{9D8B030D-6E8A-4147-A177-3AD203B41FA5}">
                      <a16:colId xmlns:a16="http://schemas.microsoft.com/office/drawing/2014/main" val="2762879117"/>
                    </a:ext>
                  </a:extLst>
                </a:gridCol>
                <a:gridCol w="175704">
                  <a:extLst>
                    <a:ext uri="{9D8B030D-6E8A-4147-A177-3AD203B41FA5}">
                      <a16:colId xmlns:a16="http://schemas.microsoft.com/office/drawing/2014/main" val="1185721839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800111385"/>
                    </a:ext>
                  </a:extLst>
                </a:gridCol>
                <a:gridCol w="184877">
                  <a:extLst>
                    <a:ext uri="{9D8B030D-6E8A-4147-A177-3AD203B41FA5}">
                      <a16:colId xmlns:a16="http://schemas.microsoft.com/office/drawing/2014/main" val="1334503297"/>
                    </a:ext>
                  </a:extLst>
                </a:gridCol>
                <a:gridCol w="179637">
                  <a:extLst>
                    <a:ext uri="{9D8B030D-6E8A-4147-A177-3AD203B41FA5}">
                      <a16:colId xmlns:a16="http://schemas.microsoft.com/office/drawing/2014/main" val="3123306252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464090841"/>
                    </a:ext>
                  </a:extLst>
                </a:gridCol>
                <a:gridCol w="162064">
                  <a:extLst>
                    <a:ext uri="{9D8B030D-6E8A-4147-A177-3AD203B41FA5}">
                      <a16:colId xmlns:a16="http://schemas.microsoft.com/office/drawing/2014/main" val="3162358688"/>
                    </a:ext>
                  </a:extLst>
                </a:gridCol>
                <a:gridCol w="244170">
                  <a:extLst>
                    <a:ext uri="{9D8B030D-6E8A-4147-A177-3AD203B41FA5}">
                      <a16:colId xmlns:a16="http://schemas.microsoft.com/office/drawing/2014/main" val="389610847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1773961963"/>
                    </a:ext>
                  </a:extLst>
                </a:gridCol>
                <a:gridCol w="162495">
                  <a:extLst>
                    <a:ext uri="{9D8B030D-6E8A-4147-A177-3AD203B41FA5}">
                      <a16:colId xmlns:a16="http://schemas.microsoft.com/office/drawing/2014/main" val="801284915"/>
                    </a:ext>
                  </a:extLst>
                </a:gridCol>
                <a:gridCol w="209775">
                  <a:extLst>
                    <a:ext uri="{9D8B030D-6E8A-4147-A177-3AD203B41FA5}">
                      <a16:colId xmlns:a16="http://schemas.microsoft.com/office/drawing/2014/main" val="2137659426"/>
                    </a:ext>
                  </a:extLst>
                </a:gridCol>
              </a:tblGrid>
              <a:tr h="14956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6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8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443380"/>
                  </a:ext>
                </a:extLst>
              </a:tr>
              <a:tr h="2720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69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0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2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3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5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76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78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77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7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EA 588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0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9</a:t>
                      </a:r>
                    </a:p>
                  </a:txBody>
                  <a:tcPr marL="16004" marR="16004" marT="10669" marB="10669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605205"/>
                  </a:ext>
                </a:extLst>
              </a:tr>
              <a:tr h="322596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5860197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1888846"/>
              </p:ext>
            </p:extLst>
          </p:nvPr>
        </p:nvGraphicFramePr>
        <p:xfrm>
          <a:off x="3955178" y="968517"/>
          <a:ext cx="2697726" cy="744190"/>
        </p:xfrm>
        <a:graphic>
          <a:graphicData uri="http://schemas.openxmlformats.org/drawingml/2006/table">
            <a:tbl>
              <a:tblPr/>
              <a:tblGrid>
                <a:gridCol w="149944">
                  <a:extLst>
                    <a:ext uri="{9D8B030D-6E8A-4147-A177-3AD203B41FA5}">
                      <a16:colId xmlns:a16="http://schemas.microsoft.com/office/drawing/2014/main" val="4017611445"/>
                    </a:ext>
                  </a:extLst>
                </a:gridCol>
                <a:gridCol w="209992">
                  <a:extLst>
                    <a:ext uri="{9D8B030D-6E8A-4147-A177-3AD203B41FA5}">
                      <a16:colId xmlns:a16="http://schemas.microsoft.com/office/drawing/2014/main" val="2901846887"/>
                    </a:ext>
                  </a:extLst>
                </a:gridCol>
                <a:gridCol w="183190">
                  <a:extLst>
                    <a:ext uri="{9D8B030D-6E8A-4147-A177-3AD203B41FA5}">
                      <a16:colId xmlns:a16="http://schemas.microsoft.com/office/drawing/2014/main" val="1531593738"/>
                    </a:ext>
                  </a:extLst>
                </a:gridCol>
                <a:gridCol w="237619">
                  <a:extLst>
                    <a:ext uri="{9D8B030D-6E8A-4147-A177-3AD203B41FA5}">
                      <a16:colId xmlns:a16="http://schemas.microsoft.com/office/drawing/2014/main" val="2762879117"/>
                    </a:ext>
                  </a:extLst>
                </a:gridCol>
                <a:gridCol w="175704">
                  <a:extLst>
                    <a:ext uri="{9D8B030D-6E8A-4147-A177-3AD203B41FA5}">
                      <a16:colId xmlns:a16="http://schemas.microsoft.com/office/drawing/2014/main" val="1185721839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800111385"/>
                    </a:ext>
                  </a:extLst>
                </a:gridCol>
                <a:gridCol w="184877">
                  <a:extLst>
                    <a:ext uri="{9D8B030D-6E8A-4147-A177-3AD203B41FA5}">
                      <a16:colId xmlns:a16="http://schemas.microsoft.com/office/drawing/2014/main" val="1334503297"/>
                    </a:ext>
                  </a:extLst>
                </a:gridCol>
                <a:gridCol w="179637">
                  <a:extLst>
                    <a:ext uri="{9D8B030D-6E8A-4147-A177-3AD203B41FA5}">
                      <a16:colId xmlns:a16="http://schemas.microsoft.com/office/drawing/2014/main" val="3123306252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464090841"/>
                    </a:ext>
                  </a:extLst>
                </a:gridCol>
                <a:gridCol w="162064">
                  <a:extLst>
                    <a:ext uri="{9D8B030D-6E8A-4147-A177-3AD203B41FA5}">
                      <a16:colId xmlns:a16="http://schemas.microsoft.com/office/drawing/2014/main" val="3162358688"/>
                    </a:ext>
                  </a:extLst>
                </a:gridCol>
                <a:gridCol w="244170">
                  <a:extLst>
                    <a:ext uri="{9D8B030D-6E8A-4147-A177-3AD203B41FA5}">
                      <a16:colId xmlns:a16="http://schemas.microsoft.com/office/drawing/2014/main" val="3896108471"/>
                    </a:ext>
                  </a:extLst>
                </a:gridCol>
                <a:gridCol w="203117">
                  <a:extLst>
                    <a:ext uri="{9D8B030D-6E8A-4147-A177-3AD203B41FA5}">
                      <a16:colId xmlns:a16="http://schemas.microsoft.com/office/drawing/2014/main" val="1773961963"/>
                    </a:ext>
                  </a:extLst>
                </a:gridCol>
                <a:gridCol w="162495">
                  <a:extLst>
                    <a:ext uri="{9D8B030D-6E8A-4147-A177-3AD203B41FA5}">
                      <a16:colId xmlns:a16="http://schemas.microsoft.com/office/drawing/2014/main" val="801284915"/>
                    </a:ext>
                  </a:extLst>
                </a:gridCol>
                <a:gridCol w="209775">
                  <a:extLst>
                    <a:ext uri="{9D8B030D-6E8A-4147-A177-3AD203B41FA5}">
                      <a16:colId xmlns:a16="http://schemas.microsoft.com/office/drawing/2014/main" val="2137659426"/>
                    </a:ext>
                  </a:extLst>
                </a:gridCol>
              </a:tblGrid>
              <a:tr h="14956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1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80CA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5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6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CE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7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F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 dirty="0">
                          <a:effectLst/>
                        </a:rPr>
                        <a:t>8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0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9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CD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0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1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00D2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2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A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3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40D1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b="1">
                          <a:effectLst/>
                        </a:rPr>
                        <a:t>14</a:t>
                      </a:r>
                    </a:p>
                  </a:txBody>
                  <a:tcPr marL="14897" marR="14897" marT="0" marB="0" anchor="ctr">
                    <a:lnL w="7620" cap="flat" cmpd="sng" algn="ctr">
                      <a:solidFill>
                        <a:srgbClr val="C0D42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9443380"/>
                  </a:ext>
                </a:extLst>
              </a:tr>
              <a:tr h="27202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1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2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5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3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4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6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600" dirty="0">
                          <a:effectLst/>
                        </a:rPr>
                        <a:t>L</a:t>
                      </a: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7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8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0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1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9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2</a:t>
                      </a:r>
                    </a:p>
                  </a:txBody>
                  <a:tcPr marL="17468" marR="17468" marT="11646" marB="11646" anchor="b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9605205"/>
                  </a:ext>
                </a:extLst>
              </a:tr>
              <a:tr h="322596"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Fisetin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600" b="1" dirty="0">
                        <a:effectLst/>
                      </a:endParaRPr>
                    </a:p>
                  </a:txBody>
                  <a:tcPr marL="14897" marR="1489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Fisetin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Fisetin</a:t>
                      </a:r>
                    </a:p>
                  </a:txBody>
                  <a:tcPr marL="18517" marR="18517" marT="0" marB="0" anchor="ctr">
                    <a:lnL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5860197"/>
                  </a:ext>
                </a:extLst>
              </a:tr>
            </a:tbl>
          </a:graphicData>
        </a:graphic>
      </p:graphicFrame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668" b="20028"/>
          <a:stretch/>
        </p:blipFill>
        <p:spPr>
          <a:xfrm>
            <a:off x="3868383" y="3736396"/>
            <a:ext cx="2901852" cy="3979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416" b="14407"/>
          <a:stretch/>
        </p:blipFill>
        <p:spPr>
          <a:xfrm>
            <a:off x="790263" y="3664793"/>
            <a:ext cx="2981992" cy="499265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-1475" y="3727661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598798" y="2267700"/>
            <a:ext cx="868607" cy="26989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2675608" y="3158455"/>
            <a:ext cx="868607" cy="26989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2675608" y="3732305"/>
            <a:ext cx="868607" cy="26989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9311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9" t="44380" b="16281"/>
          <a:stretch/>
        </p:blipFill>
        <p:spPr>
          <a:xfrm>
            <a:off x="932675" y="2037270"/>
            <a:ext cx="2522451" cy="16130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10206" y="2141308"/>
            <a:ext cx="88614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17,19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9553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6C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26922" y="3951964"/>
            <a:ext cx="8902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otal caspase-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5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5095" y="555420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Table 17"/>
          <p:cNvGraphicFramePr>
            <a:graphicFrameLocks noGrp="1"/>
          </p:cNvGraphicFramePr>
          <p:nvPr/>
        </p:nvGraphicFramePr>
        <p:xfrm>
          <a:off x="960283" y="1252017"/>
          <a:ext cx="2430310" cy="587087"/>
        </p:xfrm>
        <a:graphic>
          <a:graphicData uri="http://schemas.openxmlformats.org/drawingml/2006/table">
            <a:tbl>
              <a:tblPr/>
              <a:tblGrid>
                <a:gridCol w="173665">
                  <a:extLst>
                    <a:ext uri="{9D8B030D-6E8A-4147-A177-3AD203B41FA5}">
                      <a16:colId xmlns:a16="http://schemas.microsoft.com/office/drawing/2014/main" val="2840895888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445124810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767701365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152635847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723487671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164662505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286242006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637320716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379935052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514973245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1269408134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4042475507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289669197"/>
                    </a:ext>
                  </a:extLst>
                </a:gridCol>
                <a:gridCol w="172665">
                  <a:extLst>
                    <a:ext uri="{9D8B030D-6E8A-4147-A177-3AD203B41FA5}">
                      <a16:colId xmlns:a16="http://schemas.microsoft.com/office/drawing/2014/main" val="1464336945"/>
                    </a:ext>
                  </a:extLst>
                </a:gridCol>
              </a:tblGrid>
              <a:tr h="9269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814677"/>
                  </a:ext>
                </a:extLst>
              </a:tr>
              <a:tr h="1853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5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193542"/>
                  </a:ext>
                </a:extLst>
              </a:tr>
              <a:tr h="308993">
                <a:tc>
                  <a:txBody>
                    <a:bodyPr/>
                    <a:lstStyle/>
                    <a:p>
                      <a:pPr algn="ctr" rtl="0" fontAlgn="b"/>
                      <a:endParaRPr lang="en-US" sz="6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245024"/>
                  </a:ext>
                </a:extLst>
              </a:tr>
            </a:tbl>
          </a:graphicData>
        </a:graphic>
      </p:graphicFrame>
      <p:graphicFrame>
        <p:nvGraphicFramePr>
          <p:cNvPr id="19" name="Table 18"/>
          <p:cNvGraphicFramePr>
            <a:graphicFrameLocks noGrp="1"/>
          </p:cNvGraphicFramePr>
          <p:nvPr/>
        </p:nvGraphicFramePr>
        <p:xfrm>
          <a:off x="3736240" y="1227720"/>
          <a:ext cx="2688350" cy="579120"/>
        </p:xfrm>
        <a:graphic>
          <a:graphicData uri="http://schemas.openxmlformats.org/drawingml/2006/table">
            <a:tbl>
              <a:tblPr/>
              <a:tblGrid>
                <a:gridCol w="192025">
                  <a:extLst>
                    <a:ext uri="{9D8B030D-6E8A-4147-A177-3AD203B41FA5}">
                      <a16:colId xmlns:a16="http://schemas.microsoft.com/office/drawing/2014/main" val="2840895888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445124810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767701365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152635847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723487671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164662505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286242006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637320716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379935052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514973245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1269408134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4042475507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289669197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1464336945"/>
                    </a:ext>
                  </a:extLst>
                </a:gridCol>
              </a:tblGrid>
              <a:tr h="963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814677"/>
                  </a:ext>
                </a:extLst>
              </a:tr>
              <a:tr h="19277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1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2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3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4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5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6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7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8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9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0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1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2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193542"/>
                  </a:ext>
                </a:extLst>
              </a:tr>
              <a:tr h="289959">
                <a:tc>
                  <a:txBody>
                    <a:bodyPr/>
                    <a:lstStyle/>
                    <a:p>
                      <a:pPr algn="ctr" rtl="0" fontAlgn="b"/>
                      <a:endParaRPr lang="en-US" sz="6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245024"/>
                  </a:ext>
                </a:extLst>
              </a:tr>
            </a:tbl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014" r="3305" b="23774"/>
          <a:stretch/>
        </p:blipFill>
        <p:spPr>
          <a:xfrm>
            <a:off x="929618" y="3727090"/>
            <a:ext cx="2614597" cy="168982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1" t="45317" b="44380"/>
          <a:stretch/>
        </p:blipFill>
        <p:spPr>
          <a:xfrm>
            <a:off x="934547" y="5543163"/>
            <a:ext cx="2494453" cy="42245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177"/>
          <a:stretch/>
        </p:blipFill>
        <p:spPr>
          <a:xfrm>
            <a:off x="3664821" y="1949422"/>
            <a:ext cx="2981992" cy="165938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860" b="-162"/>
          <a:stretch/>
        </p:blipFill>
        <p:spPr>
          <a:xfrm>
            <a:off x="3736240" y="3713967"/>
            <a:ext cx="2981992" cy="154932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164" b="11397"/>
          <a:stretch/>
        </p:blipFill>
        <p:spPr>
          <a:xfrm>
            <a:off x="3666949" y="5519879"/>
            <a:ext cx="2981992" cy="46902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8" name="Rectangle 27"/>
          <p:cNvSpPr/>
          <p:nvPr/>
        </p:nvSpPr>
        <p:spPr>
          <a:xfrm>
            <a:off x="974919" y="3837511"/>
            <a:ext cx="966736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952042" y="2779112"/>
            <a:ext cx="966736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952196" y="5639938"/>
            <a:ext cx="966736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8681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974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6D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5095" y="4107058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Table 17"/>
          <p:cNvGraphicFramePr>
            <a:graphicFrameLocks noGrp="1"/>
          </p:cNvGraphicFramePr>
          <p:nvPr/>
        </p:nvGraphicFramePr>
        <p:xfrm>
          <a:off x="960283" y="1252017"/>
          <a:ext cx="2430310" cy="587087"/>
        </p:xfrm>
        <a:graphic>
          <a:graphicData uri="http://schemas.openxmlformats.org/drawingml/2006/table">
            <a:tbl>
              <a:tblPr/>
              <a:tblGrid>
                <a:gridCol w="173665">
                  <a:extLst>
                    <a:ext uri="{9D8B030D-6E8A-4147-A177-3AD203B41FA5}">
                      <a16:colId xmlns:a16="http://schemas.microsoft.com/office/drawing/2014/main" val="2840895888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445124810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767701365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152635847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723487671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164662505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286242006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637320716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2379935052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514973245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1269408134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4042475507"/>
                    </a:ext>
                  </a:extLst>
                </a:gridCol>
                <a:gridCol w="173665">
                  <a:extLst>
                    <a:ext uri="{9D8B030D-6E8A-4147-A177-3AD203B41FA5}">
                      <a16:colId xmlns:a16="http://schemas.microsoft.com/office/drawing/2014/main" val="3289669197"/>
                    </a:ext>
                  </a:extLst>
                </a:gridCol>
                <a:gridCol w="172665">
                  <a:extLst>
                    <a:ext uri="{9D8B030D-6E8A-4147-A177-3AD203B41FA5}">
                      <a16:colId xmlns:a16="http://schemas.microsoft.com/office/drawing/2014/main" val="1464336945"/>
                    </a:ext>
                  </a:extLst>
                </a:gridCol>
              </a:tblGrid>
              <a:tr h="9269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814677"/>
                  </a:ext>
                </a:extLst>
              </a:tr>
              <a:tr h="1853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5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193542"/>
                  </a:ext>
                </a:extLst>
              </a:tr>
              <a:tr h="308993">
                <a:tc>
                  <a:txBody>
                    <a:bodyPr/>
                    <a:lstStyle/>
                    <a:p>
                      <a:pPr algn="ctr" rtl="0" fontAlgn="b"/>
                      <a:endParaRPr lang="en-US" sz="6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245024"/>
                  </a:ext>
                </a:extLst>
              </a:tr>
            </a:tbl>
          </a:graphicData>
        </a:graphic>
      </p:graphicFrame>
      <p:graphicFrame>
        <p:nvGraphicFramePr>
          <p:cNvPr id="19" name="Table 18"/>
          <p:cNvGraphicFramePr>
            <a:graphicFrameLocks noGrp="1"/>
          </p:cNvGraphicFramePr>
          <p:nvPr/>
        </p:nvGraphicFramePr>
        <p:xfrm>
          <a:off x="3736240" y="1227720"/>
          <a:ext cx="2688350" cy="579120"/>
        </p:xfrm>
        <a:graphic>
          <a:graphicData uri="http://schemas.openxmlformats.org/drawingml/2006/table">
            <a:tbl>
              <a:tblPr/>
              <a:tblGrid>
                <a:gridCol w="192025">
                  <a:extLst>
                    <a:ext uri="{9D8B030D-6E8A-4147-A177-3AD203B41FA5}">
                      <a16:colId xmlns:a16="http://schemas.microsoft.com/office/drawing/2014/main" val="2840895888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445124810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767701365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152635847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723487671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164662505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286242006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637320716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2379935052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514973245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1269408134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4042475507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3289669197"/>
                    </a:ext>
                  </a:extLst>
                </a:gridCol>
                <a:gridCol w="192025">
                  <a:extLst>
                    <a:ext uri="{9D8B030D-6E8A-4147-A177-3AD203B41FA5}">
                      <a16:colId xmlns:a16="http://schemas.microsoft.com/office/drawing/2014/main" val="1464336945"/>
                    </a:ext>
                  </a:extLst>
                </a:gridCol>
              </a:tblGrid>
              <a:tr h="963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814677"/>
                  </a:ext>
                </a:extLst>
              </a:tr>
              <a:tr h="19277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1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2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3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4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5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6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7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8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9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0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1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2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193542"/>
                  </a:ext>
                </a:extLst>
              </a:tr>
              <a:tr h="289959">
                <a:tc>
                  <a:txBody>
                    <a:bodyPr/>
                    <a:lstStyle/>
                    <a:p>
                      <a:pPr algn="ctr" rtl="0" fontAlgn="b"/>
                      <a:endParaRPr lang="en-US" sz="6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245024"/>
                  </a:ext>
                </a:extLst>
              </a:tr>
            </a:tbl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1" t="45317" b="44380"/>
          <a:stretch/>
        </p:blipFill>
        <p:spPr>
          <a:xfrm>
            <a:off x="934547" y="4096019"/>
            <a:ext cx="2494453" cy="42245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164" b="11397"/>
          <a:stretch/>
        </p:blipFill>
        <p:spPr>
          <a:xfrm>
            <a:off x="3666949" y="4072735"/>
            <a:ext cx="2981992" cy="46902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32" name="Rectangle 31"/>
          <p:cNvSpPr/>
          <p:nvPr/>
        </p:nvSpPr>
        <p:spPr>
          <a:xfrm>
            <a:off x="3812733" y="4151246"/>
            <a:ext cx="966736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15390" y="2012028"/>
            <a:ext cx="6850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89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0" y="3292156"/>
            <a:ext cx="8902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otal PARP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116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5" t="80910" b="6165"/>
          <a:stretch/>
        </p:blipFill>
        <p:spPr>
          <a:xfrm>
            <a:off x="3666949" y="1998865"/>
            <a:ext cx="2834451" cy="52998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40" b="22837"/>
          <a:stretch/>
        </p:blipFill>
        <p:spPr>
          <a:xfrm>
            <a:off x="3666948" y="2972271"/>
            <a:ext cx="2911261" cy="58791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4023"/>
          <a:stretch/>
        </p:blipFill>
        <p:spPr>
          <a:xfrm>
            <a:off x="866635" y="2114080"/>
            <a:ext cx="2634142" cy="29037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480" r="827" b="16968"/>
          <a:stretch/>
        </p:blipFill>
        <p:spPr>
          <a:xfrm>
            <a:off x="988986" y="3022345"/>
            <a:ext cx="2600652" cy="48192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8" name="Rectangle 27"/>
          <p:cNvSpPr/>
          <p:nvPr/>
        </p:nvSpPr>
        <p:spPr>
          <a:xfrm>
            <a:off x="3813050" y="2267700"/>
            <a:ext cx="966736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3813050" y="3263306"/>
            <a:ext cx="966736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486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3074" y="6492250"/>
            <a:ext cx="2775510" cy="53605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13382" y="2237299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6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69300" y="524696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969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7A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169300" y="3996608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0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43" name="Table 4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055673"/>
              </p:ext>
            </p:extLst>
          </p:nvPr>
        </p:nvGraphicFramePr>
        <p:xfrm>
          <a:off x="1071127" y="923525"/>
          <a:ext cx="2555280" cy="670854"/>
        </p:xfrm>
        <a:graphic>
          <a:graphicData uri="http://schemas.openxmlformats.org/drawingml/2006/table">
            <a:tbl>
              <a:tblPr/>
              <a:tblGrid>
                <a:gridCol w="255528">
                  <a:extLst>
                    <a:ext uri="{9D8B030D-6E8A-4147-A177-3AD203B41FA5}">
                      <a16:colId xmlns:a16="http://schemas.microsoft.com/office/drawing/2014/main" val="2736496929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790039880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293139762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1098291790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1856708151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423602161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3050626561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2327325032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1513896827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2390133130"/>
                    </a:ext>
                  </a:extLst>
                </a:gridCol>
              </a:tblGrid>
              <a:tr h="13745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8517" marR="18517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8093913"/>
                  </a:ext>
                </a:extLst>
              </a:tr>
              <a:tr h="160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8517" marR="18517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69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0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2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5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6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8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EA 577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0578867"/>
                  </a:ext>
                </a:extLst>
              </a:tr>
              <a:tr h="274908">
                <a:tc>
                  <a:txBody>
                    <a:bodyPr/>
                    <a:lstStyle/>
                    <a:p>
                      <a:pPr algn="ctr" rtl="0" fontAlgn="b"/>
                      <a:endParaRPr lang="en-US" sz="7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517" marR="18517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7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1990109"/>
                  </a:ext>
                </a:extLst>
              </a:tr>
            </a:tbl>
          </a:graphicData>
        </a:graphic>
      </p:graphicFrame>
      <p:graphicFrame>
        <p:nvGraphicFramePr>
          <p:cNvPr id="88" name="Table 8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633920"/>
              </p:ext>
            </p:extLst>
          </p:nvPr>
        </p:nvGraphicFramePr>
        <p:xfrm>
          <a:off x="3880391" y="923525"/>
          <a:ext cx="2555280" cy="670854"/>
        </p:xfrm>
        <a:graphic>
          <a:graphicData uri="http://schemas.openxmlformats.org/drawingml/2006/table">
            <a:tbl>
              <a:tblPr/>
              <a:tblGrid>
                <a:gridCol w="255528">
                  <a:extLst>
                    <a:ext uri="{9D8B030D-6E8A-4147-A177-3AD203B41FA5}">
                      <a16:colId xmlns:a16="http://schemas.microsoft.com/office/drawing/2014/main" val="2736496929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790039880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293139762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1098291790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1856708151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423602161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3050626561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2327325032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1513896827"/>
                    </a:ext>
                  </a:extLst>
                </a:gridCol>
                <a:gridCol w="255528">
                  <a:extLst>
                    <a:ext uri="{9D8B030D-6E8A-4147-A177-3AD203B41FA5}">
                      <a16:colId xmlns:a16="http://schemas.microsoft.com/office/drawing/2014/main" val="2390133130"/>
                    </a:ext>
                  </a:extLst>
                </a:gridCol>
              </a:tblGrid>
              <a:tr h="13745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8517" marR="18517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8517" marR="18517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8093913"/>
                  </a:ext>
                </a:extLst>
              </a:tr>
              <a:tr h="160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8517" marR="1851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7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8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90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9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1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2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4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EA 585</a:t>
                      </a:r>
                    </a:p>
                  </a:txBody>
                  <a:tcPr marL="22860" marR="22860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0578867"/>
                  </a:ext>
                </a:extLst>
              </a:tr>
              <a:tr h="274908">
                <a:tc>
                  <a:txBody>
                    <a:bodyPr/>
                    <a:lstStyle/>
                    <a:p>
                      <a:pPr algn="ctr" rtl="0" fontAlgn="b"/>
                      <a:endParaRPr lang="en-US" sz="7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517" marR="1851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7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7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1990109"/>
                  </a:ext>
                </a:extLst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823" b="43444"/>
          <a:stretch/>
        </p:blipFill>
        <p:spPr>
          <a:xfrm>
            <a:off x="976980" y="4965932"/>
            <a:ext cx="2652646" cy="7681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887" b="26584"/>
          <a:stretch/>
        </p:blipFill>
        <p:spPr>
          <a:xfrm>
            <a:off x="959456" y="3304635"/>
            <a:ext cx="2666951" cy="14977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507" b="36887"/>
          <a:stretch/>
        </p:blipFill>
        <p:spPr>
          <a:xfrm>
            <a:off x="3850766" y="4970018"/>
            <a:ext cx="2584905" cy="76401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263" b="23271"/>
          <a:stretch/>
        </p:blipFill>
        <p:spPr>
          <a:xfrm>
            <a:off x="3794929" y="1669254"/>
            <a:ext cx="2640742" cy="15362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63" b="13471"/>
          <a:stretch/>
        </p:blipFill>
        <p:spPr>
          <a:xfrm>
            <a:off x="947003" y="1669254"/>
            <a:ext cx="2679404" cy="15362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402" b="24132"/>
          <a:stretch/>
        </p:blipFill>
        <p:spPr>
          <a:xfrm>
            <a:off x="3794929" y="3307075"/>
            <a:ext cx="2640742" cy="15362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5" name="Rectangle 64"/>
          <p:cNvSpPr/>
          <p:nvPr/>
        </p:nvSpPr>
        <p:spPr>
          <a:xfrm>
            <a:off x="1344383" y="3552477"/>
            <a:ext cx="548417" cy="2521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1344382" y="5481926"/>
            <a:ext cx="548417" cy="2521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1218421" y="2000475"/>
            <a:ext cx="559164" cy="252106"/>
          </a:xfrm>
          <a:prstGeom prst="rect">
            <a:avLst/>
          </a:prstGeom>
          <a:noFill/>
          <a:ln w="127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0898" y="6508050"/>
            <a:ext cx="2775510" cy="536057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69298" y="850298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41385" y="7352074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6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3074" name="Picture 2" descr="https://lh4.googleusercontent.com/J8Pyxrc3ZypD5VtluDW97jqPGncLQ8SfFA7MP84hN2gsAYImB-NvLi7G_VxO-28V_ur78JSKw4yM-hfqEotrDcMbJyw5YEWbnz9ddtfm6pfMz0XxJyr8cq4j1Xy3cje1hPUiq_SpPUdJXczcCw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106" b="40567"/>
          <a:stretch/>
        </p:blipFill>
        <p:spPr bwMode="auto">
          <a:xfrm>
            <a:off x="976980" y="8407646"/>
            <a:ext cx="2738723" cy="690162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https://lh4.googleusercontent.com/J_UVcg9iYfdU3RFKWRft12O3nC7Pm1ctB9MEN1a6OQiRU-c1r-j8MEcGSpfYXyBz-dcF2q-6Fqk3oHRM9M-A0WW4mnl2Gb6RFIRGtpqUsq-UkIInEghCbcqcAAwG5yliYc4PQJxltcg0qP6Enw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238" b="28539"/>
          <a:stretch/>
        </p:blipFill>
        <p:spPr bwMode="auto">
          <a:xfrm>
            <a:off x="1069891" y="7005702"/>
            <a:ext cx="2731428" cy="1322872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8" name="Straight Connector 17"/>
          <p:cNvCxnSpPr/>
          <p:nvPr/>
        </p:nvCxnSpPr>
        <p:spPr>
          <a:xfrm>
            <a:off x="-32948" y="6069795"/>
            <a:ext cx="689094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079" name="Picture 7" descr="https://lh4.googleusercontent.com/n0lCte8PEoNb0mU223alEarBv4cGjPY6V2tmEi5nGlJVpvJeSoPyNW7bVUfz70Q9coEeC7HGfbIvTO8zLp0LHvwu7acWoECVAOUUBe1mTasHAXapqALJm1UEgSRnA42lxMYIPXXd0vuXXqUMnQ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668" b="27250"/>
          <a:stretch/>
        </p:blipFill>
        <p:spPr bwMode="auto">
          <a:xfrm>
            <a:off x="3942977" y="6975714"/>
            <a:ext cx="2712044" cy="1382848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https://lh5.googleusercontent.com/MwU-zBCDsa78NeH-tcuT8ORaAKsA-n1J3QTahXvlLO8JmCdNkqnpJPthXGlb0bRpHlvxoQM10nHzI0-l6T1eJSPWP2djOI3Arro9IgsbA1xx8eYqppsGdQd79VIUtbcuAx4VCtqwjhWNvz5Zcw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552" b="33407"/>
          <a:stretch/>
        </p:blipFill>
        <p:spPr bwMode="auto">
          <a:xfrm>
            <a:off x="3942976" y="8407646"/>
            <a:ext cx="2795081" cy="693358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343324" y="6117353"/>
            <a:ext cx="62905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u="sng" dirty="0"/>
              <a:t>Supplementary figure showing BCL-2 protein expression for EA.hy926 cells and HUVECs on the same blot</a:t>
            </a:r>
          </a:p>
        </p:txBody>
      </p:sp>
      <p:sp>
        <p:nvSpPr>
          <p:cNvPr id="10" name="Rectangle 8"/>
          <p:cNvSpPr>
            <a:spLocks noChangeArrowheads="1"/>
          </p:cNvSpPr>
          <p:nvPr/>
        </p:nvSpPr>
        <p:spPr bwMode="auto">
          <a:xfrm>
            <a:off x="1344382" y="6506683"/>
            <a:ext cx="184731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600"/>
          </a:p>
        </p:txBody>
      </p:sp>
    </p:spTree>
    <p:extLst>
      <p:ext uri="{BB962C8B-B14F-4D97-AF65-F5344CB8AC3E}">
        <p14:creationId xmlns:p14="http://schemas.microsoft.com/office/powerpoint/2010/main" val="29692644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7950034"/>
              </p:ext>
            </p:extLst>
          </p:nvPr>
        </p:nvGraphicFramePr>
        <p:xfrm>
          <a:off x="779676" y="1227720"/>
          <a:ext cx="2798564" cy="579120"/>
        </p:xfrm>
        <a:graphic>
          <a:graphicData uri="http://schemas.openxmlformats.org/drawingml/2006/table">
            <a:tbl>
              <a:tblPr/>
              <a:tblGrid>
                <a:gridCol w="186571">
                  <a:extLst>
                    <a:ext uri="{9D8B030D-6E8A-4147-A177-3AD203B41FA5}">
                      <a16:colId xmlns:a16="http://schemas.microsoft.com/office/drawing/2014/main" val="2840895888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2445124810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2767701365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3152635847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3723487671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2164662505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3286242006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3637320716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2379935052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514973245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1269408134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4042475507"/>
                    </a:ext>
                  </a:extLst>
                </a:gridCol>
                <a:gridCol w="186571">
                  <a:extLst>
                    <a:ext uri="{9D8B030D-6E8A-4147-A177-3AD203B41FA5}">
                      <a16:colId xmlns:a16="http://schemas.microsoft.com/office/drawing/2014/main" val="3289669197"/>
                    </a:ext>
                  </a:extLst>
                </a:gridCol>
                <a:gridCol w="185496">
                  <a:extLst>
                    <a:ext uri="{9D8B030D-6E8A-4147-A177-3AD203B41FA5}">
                      <a16:colId xmlns:a16="http://schemas.microsoft.com/office/drawing/2014/main" val="1464336945"/>
                    </a:ext>
                  </a:extLst>
                </a:gridCol>
                <a:gridCol w="187645">
                  <a:extLst>
                    <a:ext uri="{9D8B030D-6E8A-4147-A177-3AD203B41FA5}">
                      <a16:colId xmlns:a16="http://schemas.microsoft.com/office/drawing/2014/main" val="4186155381"/>
                    </a:ext>
                  </a:extLst>
                </a:gridCol>
              </a:tblGrid>
              <a:tr h="875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814677"/>
                  </a:ext>
                </a:extLst>
              </a:tr>
              <a:tr h="1751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5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6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193542"/>
                  </a:ext>
                </a:extLst>
              </a:tr>
              <a:tr h="291840">
                <a:tc>
                  <a:txBody>
                    <a:bodyPr/>
                    <a:lstStyle/>
                    <a:p>
                      <a:pPr algn="ctr" rtl="0" fontAlgn="b"/>
                      <a:endParaRPr lang="en-US" sz="6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245024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2544646"/>
              </p:ext>
            </p:extLst>
          </p:nvPr>
        </p:nvGraphicFramePr>
        <p:xfrm>
          <a:off x="3736240" y="1227720"/>
          <a:ext cx="2839155" cy="579120"/>
        </p:xfrm>
        <a:graphic>
          <a:graphicData uri="http://schemas.openxmlformats.org/drawingml/2006/table">
            <a:tbl>
              <a:tblPr/>
              <a:tblGrid>
                <a:gridCol w="189277">
                  <a:extLst>
                    <a:ext uri="{9D8B030D-6E8A-4147-A177-3AD203B41FA5}">
                      <a16:colId xmlns:a16="http://schemas.microsoft.com/office/drawing/2014/main" val="2840895888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2445124810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2767701365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3152635847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3723487671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2164662505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3286242006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3637320716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2379935052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514973245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1269408134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4042475507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3289669197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1464336945"/>
                    </a:ext>
                  </a:extLst>
                </a:gridCol>
                <a:gridCol w="189277">
                  <a:extLst>
                    <a:ext uri="{9D8B030D-6E8A-4147-A177-3AD203B41FA5}">
                      <a16:colId xmlns:a16="http://schemas.microsoft.com/office/drawing/2014/main" val="587665202"/>
                    </a:ext>
                  </a:extLst>
                </a:gridCol>
              </a:tblGrid>
              <a:tr h="963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9814677"/>
                  </a:ext>
                </a:extLst>
              </a:tr>
              <a:tr h="19277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1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2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3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4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5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6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7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8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79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0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1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1" dirty="0">
                          <a:effectLst/>
                          <a:latin typeface="Calibri" panose="020F0502020204030204" pitchFamily="34" charset="0"/>
                        </a:rPr>
                        <a:t>HUV 182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600" b="0" dirty="0">
                          <a:effectLst/>
                          <a:latin typeface="Calibri" panose="020F0502020204030204" pitchFamily="34" charset="0"/>
                        </a:rPr>
                        <a:t>ladder</a:t>
                      </a:r>
                    </a:p>
                  </a:txBody>
                  <a:tcPr marL="14244" marR="14244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193542"/>
                  </a:ext>
                </a:extLst>
              </a:tr>
              <a:tr h="289959">
                <a:tc>
                  <a:txBody>
                    <a:bodyPr/>
                    <a:lstStyle/>
                    <a:p>
                      <a:pPr algn="ctr" rtl="0" fontAlgn="b"/>
                      <a:endParaRPr lang="en-US" sz="600" b="1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226" marR="13226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CTL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DOX+</a:t>
                      </a:r>
                    </a:p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ABT-263</a:t>
                      </a:r>
                    </a:p>
                  </a:txBody>
                  <a:tcPr marL="18517" marR="18517" marT="0" marB="0" anchor="ctr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B8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500" dirty="0"/>
                    </a:p>
                  </a:txBody>
                  <a:tcPr marL="13226" marR="13226" marT="0" marB="0" anchor="b">
                    <a:lnL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7620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59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245024"/>
                  </a:ext>
                </a:extLst>
              </a:tr>
            </a:tbl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950" b="47190"/>
          <a:stretch/>
        </p:blipFill>
        <p:spPr>
          <a:xfrm>
            <a:off x="739678" y="4915547"/>
            <a:ext cx="2842055" cy="7296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7826" y="2553122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CL-2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6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747" y="5055018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47" y="3961155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CL-XL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30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810" b="29393"/>
          <a:stretch/>
        </p:blipFill>
        <p:spPr>
          <a:xfrm>
            <a:off x="3698556" y="4915548"/>
            <a:ext cx="2898804" cy="7296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775" b="43442"/>
          <a:stretch/>
        </p:blipFill>
        <p:spPr>
          <a:xfrm>
            <a:off x="3698556" y="3503076"/>
            <a:ext cx="2898804" cy="13441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34077" r="-61" b="27521"/>
          <a:stretch/>
        </p:blipFill>
        <p:spPr>
          <a:xfrm>
            <a:off x="736186" y="3503076"/>
            <a:ext cx="2842054" cy="13441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" t="34077" b="31267"/>
          <a:stretch/>
        </p:blipFill>
        <p:spPr>
          <a:xfrm>
            <a:off x="3646980" y="1973621"/>
            <a:ext cx="2928408" cy="145939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683" b="9724"/>
          <a:stretch/>
        </p:blipFill>
        <p:spPr>
          <a:xfrm>
            <a:off x="736185" y="1973621"/>
            <a:ext cx="2842055" cy="145939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cropped image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08006" y="609601"/>
            <a:ext cx="961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igure S7B</a:t>
            </a:r>
          </a:p>
        </p:txBody>
      </p:sp>
      <p:sp>
        <p:nvSpPr>
          <p:cNvPr id="17" name="Rectangle 16"/>
          <p:cNvSpPr/>
          <p:nvPr/>
        </p:nvSpPr>
        <p:spPr>
          <a:xfrm>
            <a:off x="2545685" y="3767020"/>
            <a:ext cx="467471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2545685" y="5380030"/>
            <a:ext cx="467471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2545685" y="2324217"/>
            <a:ext cx="467471" cy="22890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025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47</TotalTime>
  <Words>1918</Words>
  <Application>Microsoft Office PowerPoint</Application>
  <PresentationFormat>On-screen Show (4:3)</PresentationFormat>
  <Paragraphs>1298</Paragraphs>
  <Slides>10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ne Grant</dc:creator>
  <cp:lastModifiedBy>MDPI</cp:lastModifiedBy>
  <cp:revision>138</cp:revision>
  <cp:lastPrinted>2022-05-11T17:05:09Z</cp:lastPrinted>
  <dcterms:created xsi:type="dcterms:W3CDTF">2018-11-27T20:50:39Z</dcterms:created>
  <dcterms:modified xsi:type="dcterms:W3CDTF">2022-06-22T04:18:06Z</dcterms:modified>
</cp:coreProperties>
</file>